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40873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44" autoAdjust="0"/>
    <p:restoredTop sz="94660"/>
  </p:normalViewPr>
  <p:slideViewPr>
    <p:cSldViewPr snapToGrid="0">
      <p:cViewPr varScale="1">
        <p:scale>
          <a:sx n="58" d="100"/>
          <a:sy n="58" d="100"/>
        </p:scale>
        <p:origin x="186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621191"/>
            <a:ext cx="5447427" cy="3448756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5202944"/>
            <a:ext cx="4806554" cy="2391656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2391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45338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527403"/>
            <a:ext cx="1381884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527403"/>
            <a:ext cx="4065543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0757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560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2469624"/>
            <a:ext cx="5527537" cy="4120620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6629226"/>
            <a:ext cx="5527537" cy="2166937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421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637014"/>
            <a:ext cx="2723714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637014"/>
            <a:ext cx="2723714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566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27405"/>
            <a:ext cx="5527537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2428347"/>
            <a:ext cx="2711196" cy="1190095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3618442"/>
            <a:ext cx="2711196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2428347"/>
            <a:ext cx="2724548" cy="1190095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3618442"/>
            <a:ext cx="2724548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3006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8659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0796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660400"/>
            <a:ext cx="2066985" cy="2311400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426283"/>
            <a:ext cx="3244424" cy="7039681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971800"/>
            <a:ext cx="2066985" cy="5505627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658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660400"/>
            <a:ext cx="2066985" cy="2311400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426283"/>
            <a:ext cx="3244424" cy="7039681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971800"/>
            <a:ext cx="2066985" cy="5505627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365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527405"/>
            <a:ext cx="5527537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637014"/>
            <a:ext cx="5527537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9181397"/>
            <a:ext cx="1441966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E5C3A-6FEE-432E-9213-F3C8F5551F78}" type="datetimeFigureOut">
              <a:rPr lang="en-GB" smtClean="0"/>
              <a:t>29/1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9181397"/>
            <a:ext cx="216294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9181397"/>
            <a:ext cx="1441966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56B9A-F6A3-4E3F-A9B4-96913B7E70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457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0903" rtl="0" eaLnBrk="1" latinLnBrk="0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0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hevron 8">
            <a:extLst>
              <a:ext uri="{FF2B5EF4-FFF2-40B4-BE49-F238E27FC236}">
                <a16:creationId xmlns:a16="http://schemas.microsoft.com/office/drawing/2014/main" id="{780EF2D2-3D32-B6B8-8245-D5A910F0AC25}"/>
              </a:ext>
            </a:extLst>
          </p:cNvPr>
          <p:cNvSpPr/>
          <p:nvPr/>
        </p:nvSpPr>
        <p:spPr>
          <a:xfrm rot="6817824">
            <a:off x="1671335" y="2288163"/>
            <a:ext cx="420045" cy="585247"/>
          </a:xfrm>
          <a:prstGeom prst="chevron">
            <a:avLst>
              <a:gd name="adj" fmla="val 64912"/>
            </a:avLst>
          </a:prstGeom>
          <a:solidFill>
            <a:schemeClr val="bg1">
              <a:lumMod val="50000"/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sp>
        <p:nvSpPr>
          <p:cNvPr id="6" name="Chevron 9">
            <a:extLst>
              <a:ext uri="{FF2B5EF4-FFF2-40B4-BE49-F238E27FC236}">
                <a16:creationId xmlns:a16="http://schemas.microsoft.com/office/drawing/2014/main" id="{93559916-C493-0A44-8EDD-92D7F3AC4A8F}"/>
              </a:ext>
            </a:extLst>
          </p:cNvPr>
          <p:cNvSpPr/>
          <p:nvPr/>
        </p:nvSpPr>
        <p:spPr>
          <a:xfrm rot="285000">
            <a:off x="2710598" y="3515126"/>
            <a:ext cx="383438" cy="641120"/>
          </a:xfrm>
          <a:prstGeom prst="chevron">
            <a:avLst>
              <a:gd name="adj" fmla="val 64912"/>
            </a:avLst>
          </a:prstGeom>
          <a:solidFill>
            <a:schemeClr val="bg1">
              <a:lumMod val="50000"/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sp>
        <p:nvSpPr>
          <p:cNvPr id="7" name="Donut 7">
            <a:extLst>
              <a:ext uri="{FF2B5EF4-FFF2-40B4-BE49-F238E27FC236}">
                <a16:creationId xmlns:a16="http://schemas.microsoft.com/office/drawing/2014/main" id="{73D58293-9C54-4E2C-3931-4C2D4A1E129A}"/>
              </a:ext>
            </a:extLst>
          </p:cNvPr>
          <p:cNvSpPr/>
          <p:nvPr/>
        </p:nvSpPr>
        <p:spPr>
          <a:xfrm>
            <a:off x="1730614" y="1817405"/>
            <a:ext cx="2162347" cy="2130772"/>
          </a:xfrm>
          <a:prstGeom prst="donut">
            <a:avLst>
              <a:gd name="adj" fmla="val 8445"/>
            </a:avLst>
          </a:prstGeom>
          <a:solidFill>
            <a:schemeClr val="bg1">
              <a:lumMod val="50000"/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42AE8D-8966-54E4-DF4A-10010AA7C36A}"/>
              </a:ext>
            </a:extLst>
          </p:cNvPr>
          <p:cNvSpPr txBox="1"/>
          <p:nvPr/>
        </p:nvSpPr>
        <p:spPr>
          <a:xfrm>
            <a:off x="2402171" y="2500803"/>
            <a:ext cx="848309" cy="461665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feto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/placental</a:t>
            </a:r>
          </a:p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vascular</a:t>
            </a:r>
          </a:p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demise</a:t>
            </a:r>
          </a:p>
        </p:txBody>
      </p:sp>
      <p:sp>
        <p:nvSpPr>
          <p:cNvPr id="9" name="Chevron 10">
            <a:extLst>
              <a:ext uri="{FF2B5EF4-FFF2-40B4-BE49-F238E27FC236}">
                <a16:creationId xmlns:a16="http://schemas.microsoft.com/office/drawing/2014/main" id="{D17E7BE7-C871-1FD5-A67D-0D4F5ECB3F24}"/>
              </a:ext>
            </a:extLst>
          </p:cNvPr>
          <p:cNvSpPr/>
          <p:nvPr/>
        </p:nvSpPr>
        <p:spPr>
          <a:xfrm rot="16462544">
            <a:off x="3566690" y="2440838"/>
            <a:ext cx="410318" cy="599121"/>
          </a:xfrm>
          <a:prstGeom prst="chevron">
            <a:avLst>
              <a:gd name="adj" fmla="val 64912"/>
            </a:avLst>
          </a:prstGeom>
          <a:solidFill>
            <a:schemeClr val="bg1">
              <a:lumMod val="50000"/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D4FA751-B86D-B256-DEB6-36AA8CBE7C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6218" y="2502679"/>
            <a:ext cx="1511045" cy="111663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37570E1-06E6-D837-7796-C2EC6B4078A5}"/>
              </a:ext>
            </a:extLst>
          </p:cNvPr>
          <p:cNvSpPr txBox="1"/>
          <p:nvPr/>
        </p:nvSpPr>
        <p:spPr>
          <a:xfrm>
            <a:off x="4638426" y="2664592"/>
            <a:ext cx="11635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vasoconstriction &amp;</a:t>
            </a:r>
          </a:p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inflammation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E4F43EF-78BC-0D56-F33D-6A64AB93A307}"/>
              </a:ext>
            </a:extLst>
          </p:cNvPr>
          <p:cNvGrpSpPr/>
          <p:nvPr/>
        </p:nvGrpSpPr>
        <p:grpSpPr>
          <a:xfrm>
            <a:off x="2660276" y="4468498"/>
            <a:ext cx="722619" cy="537145"/>
            <a:chOff x="2798143" y="4357706"/>
            <a:chExt cx="773276" cy="537145"/>
          </a:xfrm>
        </p:grpSpPr>
        <p:sp>
          <p:nvSpPr>
            <p:cNvPr id="14" name="Freeform 51">
              <a:extLst>
                <a:ext uri="{FF2B5EF4-FFF2-40B4-BE49-F238E27FC236}">
                  <a16:creationId xmlns:a16="http://schemas.microsoft.com/office/drawing/2014/main" id="{A6CB0826-91E6-C0CA-2FBC-E05172EF6D6C}"/>
                </a:ext>
              </a:extLst>
            </p:cNvPr>
            <p:cNvSpPr/>
            <p:nvPr/>
          </p:nvSpPr>
          <p:spPr>
            <a:xfrm rot="1827591">
              <a:off x="2892873" y="4427204"/>
              <a:ext cx="477280" cy="371776"/>
            </a:xfrm>
            <a:custGeom>
              <a:avLst/>
              <a:gdLst>
                <a:gd name="connsiteX0" fmla="*/ 547751 w 959734"/>
                <a:gd name="connsiteY0" fmla="*/ 41576 h 958137"/>
                <a:gd name="connsiteX1" fmla="*/ 125721 w 959734"/>
                <a:gd name="connsiteY1" fmla="*/ 41576 h 958137"/>
                <a:gd name="connsiteX2" fmla="*/ 15189 w 959734"/>
                <a:gd name="connsiteY2" fmla="*/ 473655 h 958137"/>
                <a:gd name="connsiteX3" fmla="*/ 407074 w 959734"/>
                <a:gd name="connsiteY3" fmla="*/ 945927 h 958137"/>
                <a:gd name="connsiteX4" fmla="*/ 628138 w 959734"/>
                <a:gd name="connsiteY4" fmla="*/ 815299 h 958137"/>
                <a:gd name="connsiteX5" fmla="*/ 698477 w 959734"/>
                <a:gd name="connsiteY5" fmla="*/ 775105 h 958137"/>
                <a:gd name="connsiteX6" fmla="*/ 959734 w 959734"/>
                <a:gd name="connsiteY6" fmla="*/ 765057 h 9581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959734" h="958137">
                  <a:moveTo>
                    <a:pt x="547751" y="41576"/>
                  </a:moveTo>
                  <a:cubicBezTo>
                    <a:pt x="381116" y="5569"/>
                    <a:pt x="214481" y="-30437"/>
                    <a:pt x="125721" y="41576"/>
                  </a:cubicBezTo>
                  <a:cubicBezTo>
                    <a:pt x="36961" y="113589"/>
                    <a:pt x="-31703" y="322930"/>
                    <a:pt x="15189" y="473655"/>
                  </a:cubicBezTo>
                  <a:cubicBezTo>
                    <a:pt x="62081" y="624380"/>
                    <a:pt x="304916" y="888986"/>
                    <a:pt x="407074" y="945927"/>
                  </a:cubicBezTo>
                  <a:cubicBezTo>
                    <a:pt x="509232" y="1002868"/>
                    <a:pt x="579571" y="843769"/>
                    <a:pt x="628138" y="815299"/>
                  </a:cubicBezTo>
                  <a:cubicBezTo>
                    <a:pt x="676705" y="786829"/>
                    <a:pt x="643211" y="783479"/>
                    <a:pt x="698477" y="775105"/>
                  </a:cubicBezTo>
                  <a:cubicBezTo>
                    <a:pt x="753743" y="766731"/>
                    <a:pt x="856738" y="765894"/>
                    <a:pt x="959734" y="765057"/>
                  </a:cubicBezTo>
                </a:path>
              </a:pathLst>
            </a:cu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15" name="Freeform 52">
              <a:extLst>
                <a:ext uri="{FF2B5EF4-FFF2-40B4-BE49-F238E27FC236}">
                  <a16:creationId xmlns:a16="http://schemas.microsoft.com/office/drawing/2014/main" id="{1CB640E4-4F90-61FE-810B-23B8B4C3D921}"/>
                </a:ext>
              </a:extLst>
            </p:cNvPr>
            <p:cNvSpPr/>
            <p:nvPr/>
          </p:nvSpPr>
          <p:spPr>
            <a:xfrm rot="1827591">
              <a:off x="2798143" y="4357706"/>
              <a:ext cx="773276" cy="537145"/>
            </a:xfrm>
            <a:custGeom>
              <a:avLst/>
              <a:gdLst>
                <a:gd name="connsiteX0" fmla="*/ 1379497 w 1554934"/>
                <a:gd name="connsiteY0" fmla="*/ 567705 h 1384326"/>
                <a:gd name="connsiteX1" fmla="*/ 1262539 w 1554934"/>
                <a:gd name="connsiteY1" fmla="*/ 413533 h 1384326"/>
                <a:gd name="connsiteX2" fmla="*/ 1145581 w 1554934"/>
                <a:gd name="connsiteY2" fmla="*/ 147719 h 1384326"/>
                <a:gd name="connsiteX3" fmla="*/ 842553 w 1554934"/>
                <a:gd name="connsiteY3" fmla="*/ 4180 h 1384326"/>
                <a:gd name="connsiteX4" fmla="*/ 337506 w 1554934"/>
                <a:gd name="connsiteY4" fmla="*/ 57343 h 1384326"/>
                <a:gd name="connsiteX5" fmla="*/ 55744 w 1554934"/>
                <a:gd name="connsiteY5" fmla="*/ 248729 h 1384326"/>
                <a:gd name="connsiteX6" fmla="*/ 2581 w 1554934"/>
                <a:gd name="connsiteY6" fmla="*/ 716561 h 1384326"/>
                <a:gd name="connsiteX7" fmla="*/ 98274 w 1554934"/>
                <a:gd name="connsiteY7" fmla="*/ 1280087 h 1384326"/>
                <a:gd name="connsiteX8" fmla="*/ 528892 w 1554934"/>
                <a:gd name="connsiteY8" fmla="*/ 1381096 h 1384326"/>
                <a:gd name="connsiteX9" fmla="*/ 927613 w 1554934"/>
                <a:gd name="connsiteY9" fmla="*/ 1232240 h 1384326"/>
                <a:gd name="connsiteX10" fmla="*/ 1257223 w 1554934"/>
                <a:gd name="connsiteY10" fmla="*/ 1147180 h 1384326"/>
                <a:gd name="connsiteX11" fmla="*/ 1554934 w 1554934"/>
                <a:gd name="connsiteY11" fmla="*/ 1343882 h 1384326"/>
                <a:gd name="connsiteX12" fmla="*/ 1554934 w 1554934"/>
                <a:gd name="connsiteY12" fmla="*/ 1343882 h 13843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1554934" h="1384326">
                  <a:moveTo>
                    <a:pt x="1379497" y="567705"/>
                  </a:moveTo>
                  <a:cubicBezTo>
                    <a:pt x="1340511" y="525618"/>
                    <a:pt x="1301525" y="483531"/>
                    <a:pt x="1262539" y="413533"/>
                  </a:cubicBezTo>
                  <a:cubicBezTo>
                    <a:pt x="1223553" y="343535"/>
                    <a:pt x="1215579" y="215945"/>
                    <a:pt x="1145581" y="147719"/>
                  </a:cubicBezTo>
                  <a:cubicBezTo>
                    <a:pt x="1075583" y="79493"/>
                    <a:pt x="977232" y="19243"/>
                    <a:pt x="842553" y="4180"/>
                  </a:cubicBezTo>
                  <a:cubicBezTo>
                    <a:pt x="707874" y="-10883"/>
                    <a:pt x="468641" y="16585"/>
                    <a:pt x="337506" y="57343"/>
                  </a:cubicBezTo>
                  <a:cubicBezTo>
                    <a:pt x="206371" y="98101"/>
                    <a:pt x="111565" y="138859"/>
                    <a:pt x="55744" y="248729"/>
                  </a:cubicBezTo>
                  <a:cubicBezTo>
                    <a:pt x="-77" y="358599"/>
                    <a:pt x="-4507" y="544668"/>
                    <a:pt x="2581" y="716561"/>
                  </a:cubicBezTo>
                  <a:cubicBezTo>
                    <a:pt x="9669" y="888454"/>
                    <a:pt x="10555" y="1169331"/>
                    <a:pt x="98274" y="1280087"/>
                  </a:cubicBezTo>
                  <a:cubicBezTo>
                    <a:pt x="185992" y="1390843"/>
                    <a:pt x="390669" y="1389071"/>
                    <a:pt x="528892" y="1381096"/>
                  </a:cubicBezTo>
                  <a:cubicBezTo>
                    <a:pt x="667115" y="1373122"/>
                    <a:pt x="806225" y="1271226"/>
                    <a:pt x="927613" y="1232240"/>
                  </a:cubicBezTo>
                  <a:cubicBezTo>
                    <a:pt x="1049001" y="1193254"/>
                    <a:pt x="1152670" y="1128573"/>
                    <a:pt x="1257223" y="1147180"/>
                  </a:cubicBezTo>
                  <a:cubicBezTo>
                    <a:pt x="1361776" y="1165787"/>
                    <a:pt x="1554934" y="1343882"/>
                    <a:pt x="1554934" y="1343882"/>
                  </a:cubicBezTo>
                  <a:lnTo>
                    <a:pt x="1554934" y="1343882"/>
                  </a:lnTo>
                </a:path>
              </a:pathLst>
            </a:custGeom>
            <a:gradFill>
              <a:gsLst>
                <a:gs pos="35000">
                  <a:schemeClr val="accent3">
                    <a:lumMod val="5000"/>
                    <a:lumOff val="95000"/>
                  </a:schemeClr>
                </a:gs>
                <a:gs pos="97000">
                  <a:schemeClr val="accent3">
                    <a:lumMod val="45000"/>
                    <a:lumOff val="55000"/>
                  </a:schemeClr>
                </a:gs>
                <a:gs pos="77000">
                  <a:schemeClr val="bg1">
                    <a:lumMod val="65000"/>
                  </a:schemeClr>
                </a:gs>
                <a:gs pos="100000">
                  <a:schemeClr val="accent3">
                    <a:lumMod val="30000"/>
                    <a:lumOff val="70000"/>
                  </a:schemeClr>
                </a:gs>
              </a:gsLst>
              <a:lin ang="13500000" scaled="1"/>
            </a:gra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  <p:sp>
          <p:nvSpPr>
            <p:cNvPr id="16" name="Freeform 53">
              <a:extLst>
                <a:ext uri="{FF2B5EF4-FFF2-40B4-BE49-F238E27FC236}">
                  <a16:creationId xmlns:a16="http://schemas.microsoft.com/office/drawing/2014/main" id="{FAC3FC7F-39B6-6770-F2E2-195CD70D62EF}"/>
                </a:ext>
              </a:extLst>
            </p:cNvPr>
            <p:cNvSpPr/>
            <p:nvPr/>
          </p:nvSpPr>
          <p:spPr>
            <a:xfrm rot="1827591">
              <a:off x="2901305" y="4400663"/>
              <a:ext cx="434734" cy="385780"/>
            </a:xfrm>
            <a:custGeom>
              <a:avLst/>
              <a:gdLst>
                <a:gd name="connsiteX0" fmla="*/ 873407 w 874180"/>
                <a:gd name="connsiteY0" fmla="*/ 369621 h 994228"/>
                <a:gd name="connsiteX1" fmla="*/ 687337 w 874180"/>
                <a:gd name="connsiteY1" fmla="*/ 66593 h 994228"/>
                <a:gd name="connsiteX2" fmla="*/ 293932 w 874180"/>
                <a:gd name="connsiteY2" fmla="*/ 18746 h 994228"/>
                <a:gd name="connsiteX3" fmla="*/ 28118 w 874180"/>
                <a:gd name="connsiteY3" fmla="*/ 311142 h 994228"/>
                <a:gd name="connsiteX4" fmla="*/ 22802 w 874180"/>
                <a:gd name="connsiteY4" fmla="*/ 741760 h 994228"/>
                <a:gd name="connsiteX5" fmla="*/ 161025 w 874180"/>
                <a:gd name="connsiteY5" fmla="*/ 991626 h 994228"/>
                <a:gd name="connsiteX6" fmla="*/ 660755 w 874180"/>
                <a:gd name="connsiteY6" fmla="*/ 869351 h 994228"/>
                <a:gd name="connsiteX7" fmla="*/ 841509 w 874180"/>
                <a:gd name="connsiteY7" fmla="*/ 821505 h 994228"/>
                <a:gd name="connsiteX8" fmla="*/ 873407 w 874180"/>
                <a:gd name="connsiteY8" fmla="*/ 816188 h 9942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874180" h="994228">
                  <a:moveTo>
                    <a:pt x="873407" y="369621"/>
                  </a:moveTo>
                  <a:cubicBezTo>
                    <a:pt x="828661" y="247346"/>
                    <a:pt x="783916" y="125072"/>
                    <a:pt x="687337" y="66593"/>
                  </a:cubicBezTo>
                  <a:cubicBezTo>
                    <a:pt x="590758" y="8114"/>
                    <a:pt x="403802" y="-22012"/>
                    <a:pt x="293932" y="18746"/>
                  </a:cubicBezTo>
                  <a:cubicBezTo>
                    <a:pt x="184062" y="59504"/>
                    <a:pt x="73306" y="190640"/>
                    <a:pt x="28118" y="311142"/>
                  </a:cubicBezTo>
                  <a:cubicBezTo>
                    <a:pt x="-17070" y="431644"/>
                    <a:pt x="651" y="628346"/>
                    <a:pt x="22802" y="741760"/>
                  </a:cubicBezTo>
                  <a:cubicBezTo>
                    <a:pt x="44953" y="855174"/>
                    <a:pt x="54700" y="970361"/>
                    <a:pt x="161025" y="991626"/>
                  </a:cubicBezTo>
                  <a:cubicBezTo>
                    <a:pt x="267350" y="1012891"/>
                    <a:pt x="547341" y="897704"/>
                    <a:pt x="660755" y="869351"/>
                  </a:cubicBezTo>
                  <a:cubicBezTo>
                    <a:pt x="774169" y="840998"/>
                    <a:pt x="806067" y="830365"/>
                    <a:pt x="841509" y="821505"/>
                  </a:cubicBezTo>
                  <a:cubicBezTo>
                    <a:pt x="876951" y="812645"/>
                    <a:pt x="875179" y="814416"/>
                    <a:pt x="873407" y="816188"/>
                  </a:cubicBezTo>
                </a:path>
              </a:pathLst>
            </a:custGeom>
            <a:gradFill>
              <a:gsLst>
                <a:gs pos="35000">
                  <a:schemeClr val="accent3">
                    <a:lumMod val="5000"/>
                    <a:lumOff val="95000"/>
                  </a:schemeClr>
                </a:gs>
                <a:gs pos="97000">
                  <a:schemeClr val="accent3">
                    <a:lumMod val="45000"/>
                    <a:lumOff val="55000"/>
                  </a:schemeClr>
                </a:gs>
                <a:gs pos="90000">
                  <a:schemeClr val="bg1">
                    <a:lumMod val="65000"/>
                  </a:schemeClr>
                </a:gs>
                <a:gs pos="100000">
                  <a:schemeClr val="accent3">
                    <a:lumMod val="30000"/>
                    <a:lumOff val="70000"/>
                  </a:schemeClr>
                </a:gs>
              </a:gsLst>
              <a:lin ang="13500000" scaled="1"/>
            </a:gra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id="{72886F4F-89C0-5B46-045C-2654F2BEF3B5}"/>
              </a:ext>
            </a:extLst>
          </p:cNvPr>
          <p:cNvGrpSpPr/>
          <p:nvPr/>
        </p:nvGrpSpPr>
        <p:grpSpPr>
          <a:xfrm>
            <a:off x="428343" y="3521355"/>
            <a:ext cx="1692751" cy="1536196"/>
            <a:chOff x="590723" y="3401038"/>
            <a:chExt cx="1811416" cy="1536196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F074988-7B25-EB65-0D53-83E1B355334C}"/>
                </a:ext>
              </a:extLst>
            </p:cNvPr>
            <p:cNvPicPr>
              <a:picLocks noChangeAspect="1"/>
            </p:cNvPicPr>
            <p:nvPr userDrawn="1"/>
          </p:nvPicPr>
          <p:blipFill>
            <a:blip r:embed="rId3"/>
            <a:stretch>
              <a:fillRect/>
            </a:stretch>
          </p:blipFill>
          <p:spPr>
            <a:xfrm>
              <a:off x="590723" y="3401038"/>
              <a:ext cx="1652324" cy="1482151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A47D04F-EE1C-20DD-C715-761003E511DB}"/>
                </a:ext>
              </a:extLst>
            </p:cNvPr>
            <p:cNvSpPr txBox="1"/>
            <p:nvPr userDrawn="1"/>
          </p:nvSpPr>
          <p:spPr>
            <a:xfrm>
              <a:off x="1373317" y="4185305"/>
              <a:ext cx="6264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enton</a:t>
              </a:r>
            </a:p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reaction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E9DD804-25F8-8E9A-5665-5F691D0C86DD}"/>
                </a:ext>
              </a:extLst>
            </p:cNvPr>
            <p:cNvSpPr txBox="1"/>
            <p:nvPr userDrawn="1"/>
          </p:nvSpPr>
          <p:spPr>
            <a:xfrm>
              <a:off x="1356614" y="3718396"/>
              <a:ext cx="82029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oxidant</a:t>
              </a:r>
            </a:p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fences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2D37C46-FF12-4E85-A7EE-B621289A7FA3}"/>
                </a:ext>
              </a:extLst>
            </p:cNvPr>
            <p:cNvSpPr txBox="1"/>
            <p:nvPr userDrawn="1"/>
          </p:nvSpPr>
          <p:spPr>
            <a:xfrm>
              <a:off x="841538" y="4012728"/>
              <a:ext cx="6864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xidatio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D866B8D-D1CA-A4EE-CF1D-2BE5F95A1232}"/>
                </a:ext>
              </a:extLst>
            </p:cNvPr>
            <p:cNvSpPr txBox="1"/>
            <p:nvPr userDrawn="1"/>
          </p:nvSpPr>
          <p:spPr>
            <a:xfrm>
              <a:off x="1410003" y="4584028"/>
              <a:ext cx="40517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O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794A5DCE-34FC-2CD5-A368-C711571CB8AE}"/>
                </a:ext>
              </a:extLst>
            </p:cNvPr>
            <p:cNvSpPr txBox="1"/>
            <p:nvPr userDrawn="1"/>
          </p:nvSpPr>
          <p:spPr>
            <a:xfrm rot="20196349">
              <a:off x="1286801" y="4721790"/>
              <a:ext cx="1115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ipid peroxidatio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F3A0F51-A07F-31E6-508B-E85DB5C730B8}"/>
                </a:ext>
              </a:extLst>
            </p:cNvPr>
            <p:cNvSpPr txBox="1"/>
            <p:nvPr userDrawn="1"/>
          </p:nvSpPr>
          <p:spPr>
            <a:xfrm>
              <a:off x="1009814" y="3421911"/>
              <a:ext cx="7979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rythrocyte</a:t>
              </a:r>
            </a:p>
          </p:txBody>
        </p:sp>
      </p:grp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A8202D86-CEB3-9338-B5DA-FDF89E5DC52C}"/>
              </a:ext>
            </a:extLst>
          </p:cNvPr>
          <p:cNvCxnSpPr>
            <a:cxnSpLocks/>
            <a:stCxn id="23" idx="3"/>
            <a:endCxn id="119" idx="1"/>
          </p:cNvCxnSpPr>
          <p:nvPr/>
        </p:nvCxnSpPr>
        <p:spPr>
          <a:xfrm flipV="1">
            <a:off x="2078254" y="4712617"/>
            <a:ext cx="647808" cy="30292"/>
          </a:xfrm>
          <a:prstGeom prst="straightConnector1">
            <a:avLst/>
          </a:prstGeom>
          <a:ln w="317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CB1914CD-48E4-C333-1E88-C8EEBF44688F}"/>
              </a:ext>
            </a:extLst>
          </p:cNvPr>
          <p:cNvSpPr txBox="1"/>
          <p:nvPr/>
        </p:nvSpPr>
        <p:spPr>
          <a:xfrm>
            <a:off x="4389713" y="4281508"/>
            <a:ext cx="9220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excessive free </a:t>
            </a:r>
          </a:p>
          <a:p>
            <a:pPr algn="ctr"/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heme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GB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HbF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FF792C41-A3CA-DD3C-88D0-8DFBAA9C8DEE}"/>
              </a:ext>
            </a:extLst>
          </p:cNvPr>
          <p:cNvGrpSpPr/>
          <p:nvPr/>
        </p:nvGrpSpPr>
        <p:grpSpPr>
          <a:xfrm>
            <a:off x="1767955" y="439587"/>
            <a:ext cx="1254432" cy="679125"/>
            <a:chOff x="2355401" y="758717"/>
            <a:chExt cx="1342370" cy="817641"/>
          </a:xfrm>
        </p:grpSpPr>
        <p:sp>
          <p:nvSpPr>
            <p:cNvPr id="28" name="32-Point Star 14">
              <a:extLst>
                <a:ext uri="{FF2B5EF4-FFF2-40B4-BE49-F238E27FC236}">
                  <a16:creationId xmlns:a16="http://schemas.microsoft.com/office/drawing/2014/main" id="{A51F6F51-92EB-36D0-3D8D-0961C9E18065}"/>
                </a:ext>
              </a:extLst>
            </p:cNvPr>
            <p:cNvSpPr/>
            <p:nvPr userDrawn="1"/>
          </p:nvSpPr>
          <p:spPr>
            <a:xfrm>
              <a:off x="2355401" y="758717"/>
              <a:ext cx="1342370" cy="817641"/>
            </a:xfrm>
            <a:prstGeom prst="star32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2E050C2-CE8F-0BCA-213E-01DE59C955D4}"/>
                </a:ext>
              </a:extLst>
            </p:cNvPr>
            <p:cNvSpPr txBox="1"/>
            <p:nvPr userDrawn="1"/>
          </p:nvSpPr>
          <p:spPr>
            <a:xfrm>
              <a:off x="2366832" y="845706"/>
              <a:ext cx="1264737" cy="7040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ypoxia -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xidative 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tress</a:t>
              </a:r>
            </a:p>
            <a:p>
              <a:pPr algn="ctr"/>
              <a:endParaRPr lang="en-GB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532F9C71-0B40-7791-2A71-3F1FF2996A40}"/>
              </a:ext>
            </a:extLst>
          </p:cNvPr>
          <p:cNvSpPr txBox="1"/>
          <p:nvPr/>
        </p:nvSpPr>
        <p:spPr>
          <a:xfrm>
            <a:off x="1494984" y="1707179"/>
            <a:ext cx="128234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↑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 placental </a:t>
            </a:r>
          </a:p>
          <a:p>
            <a:pPr algn="ctr"/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-globuli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E536796-BBFE-5B1F-EBCD-6CF374A06841}"/>
              </a:ext>
            </a:extLst>
          </p:cNvPr>
          <p:cNvSpPr txBox="1"/>
          <p:nvPr/>
        </p:nvSpPr>
        <p:spPr>
          <a:xfrm>
            <a:off x="1366869" y="1444697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↑ </a:t>
            </a:r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hif-1-</a:t>
            </a:r>
            <a:r>
              <a:rPr lang="el-GR" sz="8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rved Right Arrow 41">
            <a:extLst>
              <a:ext uri="{FF2B5EF4-FFF2-40B4-BE49-F238E27FC236}">
                <a16:creationId xmlns:a16="http://schemas.microsoft.com/office/drawing/2014/main" id="{81D0CF95-0334-AEA3-4B99-086C3803C92C}"/>
              </a:ext>
            </a:extLst>
          </p:cNvPr>
          <p:cNvSpPr/>
          <p:nvPr/>
        </p:nvSpPr>
        <p:spPr>
          <a:xfrm rot="18711806">
            <a:off x="1675311" y="1782412"/>
            <a:ext cx="252927" cy="621657"/>
          </a:xfrm>
          <a:prstGeom prst="curved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sp>
        <p:nvSpPr>
          <p:cNvPr id="33" name="Curved Right Arrow 42">
            <a:extLst>
              <a:ext uri="{FF2B5EF4-FFF2-40B4-BE49-F238E27FC236}">
                <a16:creationId xmlns:a16="http://schemas.microsoft.com/office/drawing/2014/main" id="{51B9C38A-0C11-93BF-3127-B6A33A7E524E}"/>
              </a:ext>
            </a:extLst>
          </p:cNvPr>
          <p:cNvSpPr/>
          <p:nvPr/>
        </p:nvSpPr>
        <p:spPr>
          <a:xfrm rot="7674697">
            <a:off x="2004207" y="1260059"/>
            <a:ext cx="255339" cy="538155"/>
          </a:xfrm>
          <a:prstGeom prst="curved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800">
              <a:solidFill>
                <a:schemeClr val="tx1"/>
              </a:solidFill>
            </a:endParaRP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7B9758BC-DD2E-6054-E93A-48731BCC168B}"/>
              </a:ext>
            </a:extLst>
          </p:cNvPr>
          <p:cNvGrpSpPr/>
          <p:nvPr/>
        </p:nvGrpSpPr>
        <p:grpSpPr>
          <a:xfrm rot="16738314">
            <a:off x="69493" y="1525105"/>
            <a:ext cx="1270190" cy="988878"/>
            <a:chOff x="-37059" y="781975"/>
            <a:chExt cx="2143125" cy="1895475"/>
          </a:xfrm>
        </p:grpSpPr>
        <p:sp>
          <p:nvSpPr>
            <p:cNvPr id="35" name="Freeform 43">
              <a:extLst>
                <a:ext uri="{FF2B5EF4-FFF2-40B4-BE49-F238E27FC236}">
                  <a16:creationId xmlns:a16="http://schemas.microsoft.com/office/drawing/2014/main" id="{56D72546-FE36-9A7E-B3D4-151E26C9C001}"/>
                </a:ext>
              </a:extLst>
            </p:cNvPr>
            <p:cNvSpPr/>
            <p:nvPr userDrawn="1"/>
          </p:nvSpPr>
          <p:spPr>
            <a:xfrm>
              <a:off x="-37059" y="781975"/>
              <a:ext cx="2143125" cy="1895475"/>
            </a:xfrm>
            <a:custGeom>
              <a:avLst/>
              <a:gdLst>
                <a:gd name="connsiteX0" fmla="*/ 1581150 w 2028825"/>
                <a:gd name="connsiteY0" fmla="*/ 333375 h 1828800"/>
                <a:gd name="connsiteX1" fmla="*/ 866775 w 2028825"/>
                <a:gd name="connsiteY1" fmla="*/ 914400 h 1828800"/>
                <a:gd name="connsiteX2" fmla="*/ 381000 w 2028825"/>
                <a:gd name="connsiteY2" fmla="*/ 1276350 h 1828800"/>
                <a:gd name="connsiteX3" fmla="*/ 409575 w 2028825"/>
                <a:gd name="connsiteY3" fmla="*/ 1304925 h 1828800"/>
                <a:gd name="connsiteX4" fmla="*/ 123825 w 2028825"/>
                <a:gd name="connsiteY4" fmla="*/ 1343025 h 1828800"/>
                <a:gd name="connsiteX5" fmla="*/ 0 w 2028825"/>
                <a:gd name="connsiteY5" fmla="*/ 1438275 h 1828800"/>
                <a:gd name="connsiteX6" fmla="*/ 66675 w 2028825"/>
                <a:gd name="connsiteY6" fmla="*/ 1676400 h 1828800"/>
                <a:gd name="connsiteX7" fmla="*/ 381000 w 2028825"/>
                <a:gd name="connsiteY7" fmla="*/ 1790700 h 1828800"/>
                <a:gd name="connsiteX8" fmla="*/ 609600 w 2028825"/>
                <a:gd name="connsiteY8" fmla="*/ 1828800 h 1828800"/>
                <a:gd name="connsiteX9" fmla="*/ 771525 w 2028825"/>
                <a:gd name="connsiteY9" fmla="*/ 1533525 h 1828800"/>
                <a:gd name="connsiteX10" fmla="*/ 1695450 w 2028825"/>
                <a:gd name="connsiteY10" fmla="*/ 571500 h 1828800"/>
                <a:gd name="connsiteX11" fmla="*/ 2028825 w 2028825"/>
                <a:gd name="connsiteY11" fmla="*/ 361950 h 1828800"/>
                <a:gd name="connsiteX12" fmla="*/ 1962150 w 2028825"/>
                <a:gd name="connsiteY12" fmla="*/ 47625 h 1828800"/>
                <a:gd name="connsiteX13" fmla="*/ 1666875 w 2028825"/>
                <a:gd name="connsiteY13" fmla="*/ 0 h 1828800"/>
                <a:gd name="connsiteX14" fmla="*/ 1428750 w 2028825"/>
                <a:gd name="connsiteY14" fmla="*/ 228600 h 1828800"/>
                <a:gd name="connsiteX15" fmla="*/ 1581150 w 2028825"/>
                <a:gd name="connsiteY15" fmla="*/ 333375 h 1828800"/>
                <a:gd name="connsiteX0" fmla="*/ 1581150 w 2028825"/>
                <a:gd name="connsiteY0" fmla="*/ 400050 h 1895475"/>
                <a:gd name="connsiteX1" fmla="*/ 866775 w 2028825"/>
                <a:gd name="connsiteY1" fmla="*/ 981075 h 1895475"/>
                <a:gd name="connsiteX2" fmla="*/ 381000 w 2028825"/>
                <a:gd name="connsiteY2" fmla="*/ 1343025 h 1895475"/>
                <a:gd name="connsiteX3" fmla="*/ 409575 w 2028825"/>
                <a:gd name="connsiteY3" fmla="*/ 1371600 h 1895475"/>
                <a:gd name="connsiteX4" fmla="*/ 123825 w 2028825"/>
                <a:gd name="connsiteY4" fmla="*/ 1409700 h 1895475"/>
                <a:gd name="connsiteX5" fmla="*/ 0 w 2028825"/>
                <a:gd name="connsiteY5" fmla="*/ 1504950 h 1895475"/>
                <a:gd name="connsiteX6" fmla="*/ 66675 w 2028825"/>
                <a:gd name="connsiteY6" fmla="*/ 1743075 h 1895475"/>
                <a:gd name="connsiteX7" fmla="*/ 381000 w 2028825"/>
                <a:gd name="connsiteY7" fmla="*/ 1857375 h 1895475"/>
                <a:gd name="connsiteX8" fmla="*/ 609600 w 2028825"/>
                <a:gd name="connsiteY8" fmla="*/ 1895475 h 1895475"/>
                <a:gd name="connsiteX9" fmla="*/ 771525 w 2028825"/>
                <a:gd name="connsiteY9" fmla="*/ 1600200 h 1895475"/>
                <a:gd name="connsiteX10" fmla="*/ 1695450 w 2028825"/>
                <a:gd name="connsiteY10" fmla="*/ 638175 h 1895475"/>
                <a:gd name="connsiteX11" fmla="*/ 2028825 w 2028825"/>
                <a:gd name="connsiteY11" fmla="*/ 428625 h 1895475"/>
                <a:gd name="connsiteX12" fmla="*/ 1962150 w 2028825"/>
                <a:gd name="connsiteY12" fmla="*/ 114300 h 1895475"/>
                <a:gd name="connsiteX13" fmla="*/ 1733550 w 2028825"/>
                <a:gd name="connsiteY13" fmla="*/ 0 h 1895475"/>
                <a:gd name="connsiteX14" fmla="*/ 1428750 w 2028825"/>
                <a:gd name="connsiteY14" fmla="*/ 295275 h 1895475"/>
                <a:gd name="connsiteX15" fmla="*/ 1581150 w 2028825"/>
                <a:gd name="connsiteY15" fmla="*/ 400050 h 1895475"/>
                <a:gd name="connsiteX0" fmla="*/ 1581150 w 2028825"/>
                <a:gd name="connsiteY0" fmla="*/ 400050 h 1895475"/>
                <a:gd name="connsiteX1" fmla="*/ 866775 w 2028825"/>
                <a:gd name="connsiteY1" fmla="*/ 981075 h 1895475"/>
                <a:gd name="connsiteX2" fmla="*/ 381000 w 2028825"/>
                <a:gd name="connsiteY2" fmla="*/ 1343025 h 1895475"/>
                <a:gd name="connsiteX3" fmla="*/ 409575 w 2028825"/>
                <a:gd name="connsiteY3" fmla="*/ 1371600 h 1895475"/>
                <a:gd name="connsiteX4" fmla="*/ 123825 w 2028825"/>
                <a:gd name="connsiteY4" fmla="*/ 1409700 h 1895475"/>
                <a:gd name="connsiteX5" fmla="*/ 0 w 2028825"/>
                <a:gd name="connsiteY5" fmla="*/ 1504950 h 1895475"/>
                <a:gd name="connsiteX6" fmla="*/ 66675 w 2028825"/>
                <a:gd name="connsiteY6" fmla="*/ 1743075 h 1895475"/>
                <a:gd name="connsiteX7" fmla="*/ 381000 w 2028825"/>
                <a:gd name="connsiteY7" fmla="*/ 1857375 h 1895475"/>
                <a:gd name="connsiteX8" fmla="*/ 609600 w 2028825"/>
                <a:gd name="connsiteY8" fmla="*/ 1895475 h 1895475"/>
                <a:gd name="connsiteX9" fmla="*/ 771525 w 2028825"/>
                <a:gd name="connsiteY9" fmla="*/ 1600200 h 1895475"/>
                <a:gd name="connsiteX10" fmla="*/ 1695450 w 2028825"/>
                <a:gd name="connsiteY10" fmla="*/ 638175 h 1895475"/>
                <a:gd name="connsiteX11" fmla="*/ 2028825 w 2028825"/>
                <a:gd name="connsiteY11" fmla="*/ 428625 h 1895475"/>
                <a:gd name="connsiteX12" fmla="*/ 2019300 w 2028825"/>
                <a:gd name="connsiteY12" fmla="*/ 114300 h 1895475"/>
                <a:gd name="connsiteX13" fmla="*/ 1733550 w 2028825"/>
                <a:gd name="connsiteY13" fmla="*/ 0 h 1895475"/>
                <a:gd name="connsiteX14" fmla="*/ 1428750 w 2028825"/>
                <a:gd name="connsiteY14" fmla="*/ 295275 h 1895475"/>
                <a:gd name="connsiteX15" fmla="*/ 1581150 w 2028825"/>
                <a:gd name="connsiteY15" fmla="*/ 400050 h 1895475"/>
                <a:gd name="connsiteX0" fmla="*/ 1581150 w 2076450"/>
                <a:gd name="connsiteY0" fmla="*/ 400050 h 1895475"/>
                <a:gd name="connsiteX1" fmla="*/ 866775 w 2076450"/>
                <a:gd name="connsiteY1" fmla="*/ 981075 h 1895475"/>
                <a:gd name="connsiteX2" fmla="*/ 381000 w 2076450"/>
                <a:gd name="connsiteY2" fmla="*/ 1343025 h 1895475"/>
                <a:gd name="connsiteX3" fmla="*/ 409575 w 2076450"/>
                <a:gd name="connsiteY3" fmla="*/ 1371600 h 1895475"/>
                <a:gd name="connsiteX4" fmla="*/ 123825 w 2076450"/>
                <a:gd name="connsiteY4" fmla="*/ 1409700 h 1895475"/>
                <a:gd name="connsiteX5" fmla="*/ 0 w 2076450"/>
                <a:gd name="connsiteY5" fmla="*/ 1504950 h 1895475"/>
                <a:gd name="connsiteX6" fmla="*/ 66675 w 2076450"/>
                <a:gd name="connsiteY6" fmla="*/ 1743075 h 1895475"/>
                <a:gd name="connsiteX7" fmla="*/ 381000 w 2076450"/>
                <a:gd name="connsiteY7" fmla="*/ 1857375 h 1895475"/>
                <a:gd name="connsiteX8" fmla="*/ 609600 w 2076450"/>
                <a:gd name="connsiteY8" fmla="*/ 1895475 h 1895475"/>
                <a:gd name="connsiteX9" fmla="*/ 771525 w 2076450"/>
                <a:gd name="connsiteY9" fmla="*/ 1600200 h 1895475"/>
                <a:gd name="connsiteX10" fmla="*/ 1695450 w 2076450"/>
                <a:gd name="connsiteY10" fmla="*/ 638175 h 1895475"/>
                <a:gd name="connsiteX11" fmla="*/ 2076450 w 2076450"/>
                <a:gd name="connsiteY11" fmla="*/ 428625 h 1895475"/>
                <a:gd name="connsiteX12" fmla="*/ 2019300 w 2076450"/>
                <a:gd name="connsiteY12" fmla="*/ 114300 h 1895475"/>
                <a:gd name="connsiteX13" fmla="*/ 1733550 w 2076450"/>
                <a:gd name="connsiteY13" fmla="*/ 0 h 1895475"/>
                <a:gd name="connsiteX14" fmla="*/ 1428750 w 2076450"/>
                <a:gd name="connsiteY14" fmla="*/ 295275 h 1895475"/>
                <a:gd name="connsiteX15" fmla="*/ 1581150 w 2076450"/>
                <a:gd name="connsiteY15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409575 w 2143125"/>
                <a:gd name="connsiteY3" fmla="*/ 137160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019300 w 2143125"/>
                <a:gd name="connsiteY12" fmla="*/ 114300 h 1895475"/>
                <a:gd name="connsiteX13" fmla="*/ 1733550 w 2143125"/>
                <a:gd name="connsiteY13" fmla="*/ 0 h 1895475"/>
                <a:gd name="connsiteX14" fmla="*/ 1428750 w 2143125"/>
                <a:gd name="connsiteY14" fmla="*/ 295275 h 1895475"/>
                <a:gd name="connsiteX15" fmla="*/ 1581150 w 2143125"/>
                <a:gd name="connsiteY15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409575 w 2143125"/>
                <a:gd name="connsiteY3" fmla="*/ 137160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019300 w 2143125"/>
                <a:gd name="connsiteY12" fmla="*/ 114300 h 1895475"/>
                <a:gd name="connsiteX13" fmla="*/ 1733550 w 2143125"/>
                <a:gd name="connsiteY13" fmla="*/ 0 h 1895475"/>
                <a:gd name="connsiteX14" fmla="*/ 1514475 w 2143125"/>
                <a:gd name="connsiteY14" fmla="*/ 257175 h 1895475"/>
                <a:gd name="connsiteX15" fmla="*/ 1581150 w 2143125"/>
                <a:gd name="connsiteY15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019300 w 2143125"/>
                <a:gd name="connsiteY12" fmla="*/ 114300 h 1895475"/>
                <a:gd name="connsiteX13" fmla="*/ 1733550 w 2143125"/>
                <a:gd name="connsiteY13" fmla="*/ 0 h 1895475"/>
                <a:gd name="connsiteX14" fmla="*/ 1514475 w 2143125"/>
                <a:gd name="connsiteY14" fmla="*/ 257175 h 1895475"/>
                <a:gd name="connsiteX15" fmla="*/ 1581150 w 2143125"/>
                <a:gd name="connsiteY15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057399 w 2143125"/>
                <a:gd name="connsiteY12" fmla="*/ 200026 h 1895475"/>
                <a:gd name="connsiteX13" fmla="*/ 2019300 w 2143125"/>
                <a:gd name="connsiteY13" fmla="*/ 114300 h 1895475"/>
                <a:gd name="connsiteX14" fmla="*/ 1733550 w 2143125"/>
                <a:gd name="connsiteY14" fmla="*/ 0 h 1895475"/>
                <a:gd name="connsiteX15" fmla="*/ 1514475 w 2143125"/>
                <a:gd name="connsiteY15" fmla="*/ 257175 h 1895475"/>
                <a:gd name="connsiteX16" fmla="*/ 1581150 w 2143125"/>
                <a:gd name="connsiteY16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105024 w 2143125"/>
                <a:gd name="connsiteY12" fmla="*/ 200026 h 1895475"/>
                <a:gd name="connsiteX13" fmla="*/ 2019300 w 2143125"/>
                <a:gd name="connsiteY13" fmla="*/ 114300 h 1895475"/>
                <a:gd name="connsiteX14" fmla="*/ 1733550 w 2143125"/>
                <a:gd name="connsiteY14" fmla="*/ 0 h 1895475"/>
                <a:gd name="connsiteX15" fmla="*/ 1514475 w 2143125"/>
                <a:gd name="connsiteY15" fmla="*/ 257175 h 1895475"/>
                <a:gd name="connsiteX16" fmla="*/ 1581150 w 2143125"/>
                <a:gd name="connsiteY16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105024 w 2143125"/>
                <a:gd name="connsiteY12" fmla="*/ 200026 h 1895475"/>
                <a:gd name="connsiteX13" fmla="*/ 2019300 w 2143125"/>
                <a:gd name="connsiteY13" fmla="*/ 114300 h 1895475"/>
                <a:gd name="connsiteX14" fmla="*/ 1876424 w 2143125"/>
                <a:gd name="connsiteY14" fmla="*/ 47626 h 1895475"/>
                <a:gd name="connsiteX15" fmla="*/ 1733550 w 2143125"/>
                <a:gd name="connsiteY15" fmla="*/ 0 h 1895475"/>
                <a:gd name="connsiteX16" fmla="*/ 1514475 w 2143125"/>
                <a:gd name="connsiteY16" fmla="*/ 257175 h 1895475"/>
                <a:gd name="connsiteX17" fmla="*/ 1581150 w 2143125"/>
                <a:gd name="connsiteY17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71525 w 2143125"/>
                <a:gd name="connsiteY9" fmla="*/ 1600200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105024 w 2143125"/>
                <a:gd name="connsiteY12" fmla="*/ 200026 h 1895475"/>
                <a:gd name="connsiteX13" fmla="*/ 2019300 w 2143125"/>
                <a:gd name="connsiteY13" fmla="*/ 114300 h 1895475"/>
                <a:gd name="connsiteX14" fmla="*/ 1914524 w 2143125"/>
                <a:gd name="connsiteY14" fmla="*/ 28576 h 1895475"/>
                <a:gd name="connsiteX15" fmla="*/ 1733550 w 2143125"/>
                <a:gd name="connsiteY15" fmla="*/ 0 h 1895475"/>
                <a:gd name="connsiteX16" fmla="*/ 1514475 w 2143125"/>
                <a:gd name="connsiteY16" fmla="*/ 257175 h 1895475"/>
                <a:gd name="connsiteX17" fmla="*/ 1581150 w 2143125"/>
                <a:gd name="connsiteY17" fmla="*/ 400050 h 1895475"/>
                <a:gd name="connsiteX0" fmla="*/ 1581150 w 2143125"/>
                <a:gd name="connsiteY0" fmla="*/ 400050 h 1895475"/>
                <a:gd name="connsiteX1" fmla="*/ 866775 w 2143125"/>
                <a:gd name="connsiteY1" fmla="*/ 981075 h 1895475"/>
                <a:gd name="connsiteX2" fmla="*/ 381000 w 2143125"/>
                <a:gd name="connsiteY2" fmla="*/ 1343025 h 1895475"/>
                <a:gd name="connsiteX3" fmla="*/ 266700 w 2143125"/>
                <a:gd name="connsiteY3" fmla="*/ 1352550 h 1895475"/>
                <a:gd name="connsiteX4" fmla="*/ 123825 w 2143125"/>
                <a:gd name="connsiteY4" fmla="*/ 1409700 h 1895475"/>
                <a:gd name="connsiteX5" fmla="*/ 0 w 2143125"/>
                <a:gd name="connsiteY5" fmla="*/ 1504950 h 1895475"/>
                <a:gd name="connsiteX6" fmla="*/ 66675 w 2143125"/>
                <a:gd name="connsiteY6" fmla="*/ 1743075 h 1895475"/>
                <a:gd name="connsiteX7" fmla="*/ 381000 w 2143125"/>
                <a:gd name="connsiteY7" fmla="*/ 1857375 h 1895475"/>
                <a:gd name="connsiteX8" fmla="*/ 609600 w 2143125"/>
                <a:gd name="connsiteY8" fmla="*/ 1895475 h 1895475"/>
                <a:gd name="connsiteX9" fmla="*/ 723678 w 2143125"/>
                <a:gd name="connsiteY9" fmla="*/ 1552353 h 1895475"/>
                <a:gd name="connsiteX10" fmla="*/ 1695450 w 2143125"/>
                <a:gd name="connsiteY10" fmla="*/ 638175 h 1895475"/>
                <a:gd name="connsiteX11" fmla="*/ 2143125 w 2143125"/>
                <a:gd name="connsiteY11" fmla="*/ 371475 h 1895475"/>
                <a:gd name="connsiteX12" fmla="*/ 2105024 w 2143125"/>
                <a:gd name="connsiteY12" fmla="*/ 200026 h 1895475"/>
                <a:gd name="connsiteX13" fmla="*/ 2019300 w 2143125"/>
                <a:gd name="connsiteY13" fmla="*/ 114300 h 1895475"/>
                <a:gd name="connsiteX14" fmla="*/ 1914524 w 2143125"/>
                <a:gd name="connsiteY14" fmla="*/ 28576 h 1895475"/>
                <a:gd name="connsiteX15" fmla="*/ 1733550 w 2143125"/>
                <a:gd name="connsiteY15" fmla="*/ 0 h 1895475"/>
                <a:gd name="connsiteX16" fmla="*/ 1514475 w 2143125"/>
                <a:gd name="connsiteY16" fmla="*/ 257175 h 1895475"/>
                <a:gd name="connsiteX17" fmla="*/ 1581150 w 2143125"/>
                <a:gd name="connsiteY17" fmla="*/ 400050 h 18954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</a:cxnLst>
              <a:rect l="l" t="t" r="r" b="b"/>
              <a:pathLst>
                <a:path w="2143125" h="1895475">
                  <a:moveTo>
                    <a:pt x="1581150" y="400050"/>
                  </a:moveTo>
                  <a:lnTo>
                    <a:pt x="866775" y="981075"/>
                  </a:lnTo>
                  <a:lnTo>
                    <a:pt x="381000" y="1343025"/>
                  </a:lnTo>
                  <a:lnTo>
                    <a:pt x="266700" y="1352550"/>
                  </a:lnTo>
                  <a:lnTo>
                    <a:pt x="123825" y="1409700"/>
                  </a:lnTo>
                  <a:lnTo>
                    <a:pt x="0" y="1504950"/>
                  </a:lnTo>
                  <a:lnTo>
                    <a:pt x="66675" y="1743075"/>
                  </a:lnTo>
                  <a:lnTo>
                    <a:pt x="381000" y="1857375"/>
                  </a:lnTo>
                  <a:lnTo>
                    <a:pt x="609600" y="1895475"/>
                  </a:lnTo>
                  <a:lnTo>
                    <a:pt x="723678" y="1552353"/>
                  </a:lnTo>
                  <a:lnTo>
                    <a:pt x="1695450" y="638175"/>
                  </a:lnTo>
                  <a:lnTo>
                    <a:pt x="2143125" y="371475"/>
                  </a:lnTo>
                  <a:lnTo>
                    <a:pt x="2105024" y="200026"/>
                  </a:lnTo>
                  <a:lnTo>
                    <a:pt x="2019300" y="114300"/>
                  </a:lnTo>
                  <a:lnTo>
                    <a:pt x="1914524" y="28576"/>
                  </a:lnTo>
                  <a:lnTo>
                    <a:pt x="1733550" y="0"/>
                  </a:lnTo>
                  <a:lnTo>
                    <a:pt x="1514475" y="257175"/>
                  </a:lnTo>
                  <a:lnTo>
                    <a:pt x="1581150" y="400050"/>
                  </a:lnTo>
                  <a:close/>
                </a:path>
              </a:pathLst>
            </a:custGeom>
            <a:solidFill>
              <a:schemeClr val="bg1">
                <a:lumMod val="9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  <p:sp>
          <p:nvSpPr>
            <p:cNvPr id="36" name="Freeform 48">
              <a:extLst>
                <a:ext uri="{FF2B5EF4-FFF2-40B4-BE49-F238E27FC236}">
                  <a16:creationId xmlns:a16="http://schemas.microsoft.com/office/drawing/2014/main" id="{D02047AB-5FC3-FF62-35CE-9AEC453F132B}"/>
                </a:ext>
              </a:extLst>
            </p:cNvPr>
            <p:cNvSpPr/>
            <p:nvPr userDrawn="1"/>
          </p:nvSpPr>
          <p:spPr>
            <a:xfrm>
              <a:off x="294543" y="2117442"/>
              <a:ext cx="175437" cy="16419"/>
            </a:xfrm>
            <a:custGeom>
              <a:avLst/>
              <a:gdLst>
                <a:gd name="connsiteX0" fmla="*/ 0 w 175437"/>
                <a:gd name="connsiteY0" fmla="*/ 5787 h 16419"/>
                <a:gd name="connsiteX1" fmla="*/ 138223 w 175437"/>
                <a:gd name="connsiteY1" fmla="*/ 471 h 16419"/>
                <a:gd name="connsiteX2" fmla="*/ 175437 w 175437"/>
                <a:gd name="connsiteY2" fmla="*/ 16419 h 164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75437" h="16419">
                  <a:moveTo>
                    <a:pt x="0" y="5787"/>
                  </a:moveTo>
                  <a:cubicBezTo>
                    <a:pt x="54492" y="2243"/>
                    <a:pt x="108984" y="-1301"/>
                    <a:pt x="138223" y="471"/>
                  </a:cubicBezTo>
                  <a:cubicBezTo>
                    <a:pt x="167462" y="2243"/>
                    <a:pt x="171449" y="9331"/>
                    <a:pt x="175437" y="16419"/>
                  </a:cubicBez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  <p:sp>
          <p:nvSpPr>
            <p:cNvPr id="37" name="Freeform 62">
              <a:extLst>
                <a:ext uri="{FF2B5EF4-FFF2-40B4-BE49-F238E27FC236}">
                  <a16:creationId xmlns:a16="http://schemas.microsoft.com/office/drawing/2014/main" id="{BFB08D20-3E93-F3F9-6076-8C5702B78D0E}"/>
                </a:ext>
              </a:extLst>
            </p:cNvPr>
            <p:cNvSpPr/>
            <p:nvPr userDrawn="1"/>
          </p:nvSpPr>
          <p:spPr>
            <a:xfrm>
              <a:off x="1533236" y="1171615"/>
              <a:ext cx="53163" cy="74428"/>
            </a:xfrm>
            <a:custGeom>
              <a:avLst/>
              <a:gdLst>
                <a:gd name="connsiteX0" fmla="*/ 0 w 53163"/>
                <a:gd name="connsiteY0" fmla="*/ 0 h 74428"/>
                <a:gd name="connsiteX1" fmla="*/ 53163 w 53163"/>
                <a:gd name="connsiteY1" fmla="*/ 74428 h 744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53163" h="74428">
                  <a:moveTo>
                    <a:pt x="0" y="0"/>
                  </a:moveTo>
                  <a:lnTo>
                    <a:pt x="53163" y="74428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  <p:sp>
          <p:nvSpPr>
            <p:cNvPr id="38" name="Freeform 63">
              <a:extLst>
                <a:ext uri="{FF2B5EF4-FFF2-40B4-BE49-F238E27FC236}">
                  <a16:creationId xmlns:a16="http://schemas.microsoft.com/office/drawing/2014/main" id="{AE8DAF47-BE1C-C3B1-265F-0252AF2C27C2}"/>
                </a:ext>
              </a:extLst>
            </p:cNvPr>
            <p:cNvSpPr/>
            <p:nvPr userDrawn="1"/>
          </p:nvSpPr>
          <p:spPr>
            <a:xfrm>
              <a:off x="411392" y="1222155"/>
              <a:ext cx="1237684" cy="1165688"/>
            </a:xfrm>
            <a:custGeom>
              <a:avLst/>
              <a:gdLst>
                <a:gd name="connsiteX0" fmla="*/ 1127160 w 1237684"/>
                <a:gd name="connsiteY0" fmla="*/ 29204 h 1165688"/>
                <a:gd name="connsiteX1" fmla="*/ 308453 w 1237684"/>
                <a:gd name="connsiteY1" fmla="*/ 667158 h 1165688"/>
                <a:gd name="connsiteX2" fmla="*/ 106435 w 1237684"/>
                <a:gd name="connsiteY2" fmla="*/ 917023 h 1165688"/>
                <a:gd name="connsiteX3" fmla="*/ 5425 w 1237684"/>
                <a:gd name="connsiteY3" fmla="*/ 1092460 h 1165688"/>
                <a:gd name="connsiteX4" fmla="*/ 265923 w 1237684"/>
                <a:gd name="connsiteY4" fmla="*/ 1103093 h 1165688"/>
                <a:gd name="connsiteX5" fmla="*/ 1063365 w 1237684"/>
                <a:gd name="connsiteY5" fmla="*/ 305651 h 1165688"/>
                <a:gd name="connsiteX6" fmla="*/ 1222853 w 1237684"/>
                <a:gd name="connsiteY6" fmla="*/ 124897 h 1165688"/>
                <a:gd name="connsiteX7" fmla="*/ 1127160 w 1237684"/>
                <a:gd name="connsiteY7" fmla="*/ 29204 h 11656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237684" h="1165688">
                  <a:moveTo>
                    <a:pt x="1127160" y="29204"/>
                  </a:moveTo>
                  <a:cubicBezTo>
                    <a:pt x="974760" y="119581"/>
                    <a:pt x="478574" y="519188"/>
                    <a:pt x="308453" y="667158"/>
                  </a:cubicBezTo>
                  <a:cubicBezTo>
                    <a:pt x="138332" y="815128"/>
                    <a:pt x="156940" y="846139"/>
                    <a:pt x="106435" y="917023"/>
                  </a:cubicBezTo>
                  <a:cubicBezTo>
                    <a:pt x="55930" y="987907"/>
                    <a:pt x="-21156" y="1061448"/>
                    <a:pt x="5425" y="1092460"/>
                  </a:cubicBezTo>
                  <a:cubicBezTo>
                    <a:pt x="32006" y="1123472"/>
                    <a:pt x="89600" y="1234228"/>
                    <a:pt x="265923" y="1103093"/>
                  </a:cubicBezTo>
                  <a:cubicBezTo>
                    <a:pt x="442246" y="971958"/>
                    <a:pt x="903877" y="468684"/>
                    <a:pt x="1063365" y="305651"/>
                  </a:cubicBezTo>
                  <a:cubicBezTo>
                    <a:pt x="1222853" y="142618"/>
                    <a:pt x="1212221" y="166541"/>
                    <a:pt x="1222853" y="124897"/>
                  </a:cubicBezTo>
                  <a:cubicBezTo>
                    <a:pt x="1233485" y="83253"/>
                    <a:pt x="1279560" y="-61173"/>
                    <a:pt x="1127160" y="29204"/>
                  </a:cubicBezTo>
                  <a:close/>
                </a:path>
              </a:pathLst>
            </a:custGeom>
            <a:pattFill prst="sphere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800"/>
            </a:p>
          </p:txBody>
        </p:sp>
      </p:grp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1CFFD2A6-6CD2-5F4C-A560-07B9458AACBF}"/>
              </a:ext>
            </a:extLst>
          </p:cNvPr>
          <p:cNvCxnSpPr/>
          <p:nvPr/>
        </p:nvCxnSpPr>
        <p:spPr>
          <a:xfrm>
            <a:off x="996058" y="3081784"/>
            <a:ext cx="101826" cy="32940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B61C0459-9A7F-B477-1B2F-5715176105FA}"/>
              </a:ext>
            </a:extLst>
          </p:cNvPr>
          <p:cNvCxnSpPr/>
          <p:nvPr/>
        </p:nvCxnSpPr>
        <p:spPr>
          <a:xfrm flipH="1">
            <a:off x="906472" y="1113962"/>
            <a:ext cx="868166" cy="882023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A41CB4C1-A736-02DA-A35F-A6295B439688}"/>
              </a:ext>
            </a:extLst>
          </p:cNvPr>
          <p:cNvCxnSpPr>
            <a:cxnSpLocks/>
          </p:cNvCxnSpPr>
          <p:nvPr/>
        </p:nvCxnSpPr>
        <p:spPr>
          <a:xfrm flipV="1">
            <a:off x="3297399" y="4827215"/>
            <a:ext cx="321883" cy="5555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B63105D-14B9-E61B-18DC-47FA2DE4E76D}"/>
              </a:ext>
            </a:extLst>
          </p:cNvPr>
          <p:cNvSpPr txBox="1"/>
          <p:nvPr/>
        </p:nvSpPr>
        <p:spPr>
          <a:xfrm>
            <a:off x="414787" y="2665415"/>
            <a:ext cx="13229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megaloblastic erythropoiesis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C9A25A3-08E4-74BA-BFA8-8D97C831C641}"/>
              </a:ext>
            </a:extLst>
          </p:cNvPr>
          <p:cNvSpPr txBox="1"/>
          <p:nvPr/>
        </p:nvSpPr>
        <p:spPr>
          <a:xfrm>
            <a:off x="0" y="5618749"/>
            <a:ext cx="6408738" cy="2625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200" b="1" dirty="0"/>
              <a:t>Figure S2. The vicious cycle of fetoplacental demise in fetal growth restriction and preeclampsia when </a:t>
            </a:r>
            <a:r>
              <a:rPr lang="en-GB" sz="1200" b="1" dirty="0" err="1"/>
              <a:t>heme</a:t>
            </a:r>
            <a:r>
              <a:rPr lang="en-GB" sz="1200" b="1" dirty="0"/>
              <a:t>-handling defences become depleted. </a:t>
            </a:r>
            <a:r>
              <a:rPr lang="en-GB" sz="1200" b="0" dirty="0"/>
              <a:t>This</a:t>
            </a:r>
            <a:r>
              <a:rPr lang="en-GB" sz="1200" b="0" baseline="0" dirty="0"/>
              <a:t> scenario commences with placenta hypoxia and oxidative stress, dysregulating erythropoiesis, generating megaloblastic erythrocytes, and inducing their lipid peroxidation and haemolysis. Ensuing excessive cell free haemoglobin may then overwhelm </a:t>
            </a:r>
            <a:r>
              <a:rPr lang="en-GB" sz="1200" b="0" baseline="0" dirty="0" err="1"/>
              <a:t>heme</a:t>
            </a:r>
            <a:r>
              <a:rPr lang="en-GB" sz="1200" b="0" baseline="0" dirty="0"/>
              <a:t>-handling defences, eliciting fetoplacental vascular inflammation and vasoconstriction, leading to poor fetoplacental perfusion and poor nutrient and oxygen deliver to the fetus, exacerbating fetal growth restriction. </a:t>
            </a:r>
            <a:r>
              <a:rPr lang="en-GB" sz="1200" b="1" dirty="0"/>
              <a:t> 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3E728729-1B25-4257-6B07-E075C93F9FC1}"/>
              </a:ext>
            </a:extLst>
          </p:cNvPr>
          <p:cNvCxnSpPr>
            <a:cxnSpLocks/>
          </p:cNvCxnSpPr>
          <p:nvPr/>
        </p:nvCxnSpPr>
        <p:spPr>
          <a:xfrm flipH="1" flipV="1">
            <a:off x="3141560" y="812098"/>
            <a:ext cx="746501" cy="127811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44414CB2-00FA-60C1-745A-048A710BD465}"/>
              </a:ext>
            </a:extLst>
          </p:cNvPr>
          <p:cNvSpPr txBox="1"/>
          <p:nvPr/>
        </p:nvSpPr>
        <p:spPr>
          <a:xfrm>
            <a:off x="3269127" y="230643"/>
            <a:ext cx="1426034" cy="3385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fetal growth restriction  </a:t>
            </a:r>
          </a:p>
          <a:p>
            <a:pPr algn="ctr"/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&amp; preeclampsia</a:t>
            </a:r>
          </a:p>
        </p:txBody>
      </p: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86E1492E-4452-3EB3-9ED9-7EF8CAB69089}"/>
              </a:ext>
            </a:extLst>
          </p:cNvPr>
          <p:cNvGrpSpPr/>
          <p:nvPr/>
        </p:nvGrpSpPr>
        <p:grpSpPr>
          <a:xfrm>
            <a:off x="3457508" y="456881"/>
            <a:ext cx="2635820" cy="1344736"/>
            <a:chOff x="3716254" y="482108"/>
            <a:chExt cx="2635820" cy="1344736"/>
          </a:xfrm>
        </p:grpSpPr>
        <p:sp>
          <p:nvSpPr>
            <p:cNvPr id="52" name="Left Arrow 14">
              <a:extLst>
                <a:ext uri="{FF2B5EF4-FFF2-40B4-BE49-F238E27FC236}">
                  <a16:creationId xmlns:a16="http://schemas.microsoft.com/office/drawing/2014/main" id="{B35A78D1-1720-1218-A6B6-414A819E6580}"/>
                </a:ext>
              </a:extLst>
            </p:cNvPr>
            <p:cNvSpPr/>
            <p:nvPr/>
          </p:nvSpPr>
          <p:spPr>
            <a:xfrm rot="21265725">
              <a:off x="4470354" y="671083"/>
              <a:ext cx="399805" cy="436604"/>
            </a:xfrm>
            <a:prstGeom prst="leftArrow">
              <a:avLst>
                <a:gd name="adj1" fmla="val 47938"/>
                <a:gd name="adj2" fmla="val 50000"/>
              </a:avLst>
            </a:prstGeom>
            <a:solidFill>
              <a:schemeClr val="bg1">
                <a:lumMod val="95000"/>
              </a:schemeClr>
            </a:solidFill>
            <a:ln>
              <a:solidFill>
                <a:schemeClr val="bg1">
                  <a:lumMod val="95000"/>
                  <a:alpha val="19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3" name="Freeform 7">
              <a:extLst>
                <a:ext uri="{FF2B5EF4-FFF2-40B4-BE49-F238E27FC236}">
                  <a16:creationId xmlns:a16="http://schemas.microsoft.com/office/drawing/2014/main" id="{82CA76F5-B07C-E804-B2D1-764D39196592}"/>
                </a:ext>
              </a:extLst>
            </p:cNvPr>
            <p:cNvSpPr/>
            <p:nvPr/>
          </p:nvSpPr>
          <p:spPr>
            <a:xfrm>
              <a:off x="4837448" y="573259"/>
              <a:ext cx="849907" cy="420057"/>
            </a:xfrm>
            <a:custGeom>
              <a:avLst/>
              <a:gdLst>
                <a:gd name="connsiteX0" fmla="*/ 5072332 w 5072332"/>
                <a:gd name="connsiteY0" fmla="*/ 0 h 1872008"/>
                <a:gd name="connsiteX1" fmla="*/ 4347713 w 5072332"/>
                <a:gd name="connsiteY1" fmla="*/ 664234 h 1872008"/>
                <a:gd name="connsiteX2" fmla="*/ 3717985 w 5072332"/>
                <a:gd name="connsiteY2" fmla="*/ 621101 h 1872008"/>
                <a:gd name="connsiteX3" fmla="*/ 3424687 w 5072332"/>
                <a:gd name="connsiteY3" fmla="*/ 1431984 h 1872008"/>
                <a:gd name="connsiteX4" fmla="*/ 3122762 w 5072332"/>
                <a:gd name="connsiteY4" fmla="*/ 1854679 h 1872008"/>
                <a:gd name="connsiteX5" fmla="*/ 2432649 w 5072332"/>
                <a:gd name="connsiteY5" fmla="*/ 1492369 h 1872008"/>
                <a:gd name="connsiteX6" fmla="*/ 1759789 w 5072332"/>
                <a:gd name="connsiteY6" fmla="*/ 1871932 h 1872008"/>
                <a:gd name="connsiteX7" fmla="*/ 0 w 5072332"/>
                <a:gd name="connsiteY7" fmla="*/ 1518249 h 1872008"/>
                <a:gd name="connsiteX0" fmla="*/ 3312544 w 3312544"/>
                <a:gd name="connsiteY0" fmla="*/ 0 h 1871932"/>
                <a:gd name="connsiteX1" fmla="*/ 2587925 w 3312544"/>
                <a:gd name="connsiteY1" fmla="*/ 664234 h 1871932"/>
                <a:gd name="connsiteX2" fmla="*/ 1958197 w 3312544"/>
                <a:gd name="connsiteY2" fmla="*/ 621101 h 1871932"/>
                <a:gd name="connsiteX3" fmla="*/ 1664899 w 3312544"/>
                <a:gd name="connsiteY3" fmla="*/ 1431984 h 1871932"/>
                <a:gd name="connsiteX4" fmla="*/ 1362974 w 3312544"/>
                <a:gd name="connsiteY4" fmla="*/ 1854679 h 1871932"/>
                <a:gd name="connsiteX5" fmla="*/ 672861 w 3312544"/>
                <a:gd name="connsiteY5" fmla="*/ 1492369 h 1871932"/>
                <a:gd name="connsiteX6" fmla="*/ 1 w 3312544"/>
                <a:gd name="connsiteY6" fmla="*/ 1871932 h 1871932"/>
                <a:gd name="connsiteX0" fmla="*/ 3357849 w 3357849"/>
                <a:gd name="connsiteY0" fmla="*/ 0 h 1935999"/>
                <a:gd name="connsiteX1" fmla="*/ 2633230 w 3357849"/>
                <a:gd name="connsiteY1" fmla="*/ 664234 h 1935999"/>
                <a:gd name="connsiteX2" fmla="*/ 2003502 w 3357849"/>
                <a:gd name="connsiteY2" fmla="*/ 621101 h 1935999"/>
                <a:gd name="connsiteX3" fmla="*/ 1710204 w 3357849"/>
                <a:gd name="connsiteY3" fmla="*/ 1431984 h 1935999"/>
                <a:gd name="connsiteX4" fmla="*/ 1408279 w 3357849"/>
                <a:gd name="connsiteY4" fmla="*/ 1854679 h 1935999"/>
                <a:gd name="connsiteX5" fmla="*/ 718166 w 3357849"/>
                <a:gd name="connsiteY5" fmla="*/ 1492369 h 1935999"/>
                <a:gd name="connsiteX6" fmla="*/ 45306 w 3357849"/>
                <a:gd name="connsiteY6" fmla="*/ 1871932 h 1935999"/>
                <a:gd name="connsiteX7" fmla="*/ 61965 w 3357849"/>
                <a:gd name="connsiteY7" fmla="*/ 1935999 h 1935999"/>
                <a:gd name="connsiteX0" fmla="*/ 4847318 w 4847318"/>
                <a:gd name="connsiteY0" fmla="*/ 0 h 2833297"/>
                <a:gd name="connsiteX1" fmla="*/ 4122699 w 4847318"/>
                <a:gd name="connsiteY1" fmla="*/ 664234 h 2833297"/>
                <a:gd name="connsiteX2" fmla="*/ 3492971 w 4847318"/>
                <a:gd name="connsiteY2" fmla="*/ 621101 h 2833297"/>
                <a:gd name="connsiteX3" fmla="*/ 3199673 w 4847318"/>
                <a:gd name="connsiteY3" fmla="*/ 1431984 h 2833297"/>
                <a:gd name="connsiteX4" fmla="*/ 2897748 w 4847318"/>
                <a:gd name="connsiteY4" fmla="*/ 1854679 h 2833297"/>
                <a:gd name="connsiteX5" fmla="*/ 2207635 w 4847318"/>
                <a:gd name="connsiteY5" fmla="*/ 1492369 h 2833297"/>
                <a:gd name="connsiteX6" fmla="*/ 1534775 w 4847318"/>
                <a:gd name="connsiteY6" fmla="*/ 1871932 h 2833297"/>
                <a:gd name="connsiteX7" fmla="*/ 6 w 4847318"/>
                <a:gd name="connsiteY7" fmla="*/ 2833297 h 2833297"/>
                <a:gd name="connsiteX0" fmla="*/ 6277218 w 6277218"/>
                <a:gd name="connsiteY0" fmla="*/ 0 h 3768551"/>
                <a:gd name="connsiteX1" fmla="*/ 5552599 w 6277218"/>
                <a:gd name="connsiteY1" fmla="*/ 664234 h 3768551"/>
                <a:gd name="connsiteX2" fmla="*/ 4922871 w 6277218"/>
                <a:gd name="connsiteY2" fmla="*/ 621101 h 3768551"/>
                <a:gd name="connsiteX3" fmla="*/ 4629573 w 6277218"/>
                <a:gd name="connsiteY3" fmla="*/ 1431984 h 3768551"/>
                <a:gd name="connsiteX4" fmla="*/ 4327648 w 6277218"/>
                <a:gd name="connsiteY4" fmla="*/ 1854679 h 3768551"/>
                <a:gd name="connsiteX5" fmla="*/ 3637535 w 6277218"/>
                <a:gd name="connsiteY5" fmla="*/ 1492369 h 3768551"/>
                <a:gd name="connsiteX6" fmla="*/ 2964675 w 6277218"/>
                <a:gd name="connsiteY6" fmla="*/ 1871932 h 3768551"/>
                <a:gd name="connsiteX7" fmla="*/ 0 w 6277218"/>
                <a:gd name="connsiteY7" fmla="*/ 3768551 h 376855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6277218" h="3768551">
                  <a:moveTo>
                    <a:pt x="6277218" y="0"/>
                  </a:moveTo>
                  <a:cubicBezTo>
                    <a:pt x="6027770" y="280358"/>
                    <a:pt x="5778323" y="560717"/>
                    <a:pt x="5552599" y="664234"/>
                  </a:cubicBezTo>
                  <a:cubicBezTo>
                    <a:pt x="5326874" y="767751"/>
                    <a:pt x="5076709" y="493143"/>
                    <a:pt x="4922871" y="621101"/>
                  </a:cubicBezTo>
                  <a:cubicBezTo>
                    <a:pt x="4769033" y="749059"/>
                    <a:pt x="4728777" y="1226388"/>
                    <a:pt x="4629573" y="1431984"/>
                  </a:cubicBezTo>
                  <a:cubicBezTo>
                    <a:pt x="4530369" y="1637580"/>
                    <a:pt x="4492988" y="1844615"/>
                    <a:pt x="4327648" y="1854679"/>
                  </a:cubicBezTo>
                  <a:cubicBezTo>
                    <a:pt x="4162308" y="1864743"/>
                    <a:pt x="3864697" y="1489494"/>
                    <a:pt x="3637535" y="1492369"/>
                  </a:cubicBezTo>
                  <a:cubicBezTo>
                    <a:pt x="3410373" y="1495244"/>
                    <a:pt x="3332613" y="1648444"/>
                    <a:pt x="2964675" y="1871932"/>
                  </a:cubicBezTo>
                  <a:cubicBezTo>
                    <a:pt x="2596737" y="2095420"/>
                    <a:pt x="-3470" y="3755204"/>
                    <a:pt x="0" y="3768551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4" name="Freeform 8">
              <a:extLst>
                <a:ext uri="{FF2B5EF4-FFF2-40B4-BE49-F238E27FC236}">
                  <a16:creationId xmlns:a16="http://schemas.microsoft.com/office/drawing/2014/main" id="{973C6B41-CD4B-5F48-2052-B65FE04F4982}"/>
                </a:ext>
              </a:extLst>
            </p:cNvPr>
            <p:cNvSpPr/>
            <p:nvPr/>
          </p:nvSpPr>
          <p:spPr>
            <a:xfrm>
              <a:off x="4920839" y="655893"/>
              <a:ext cx="824080" cy="443679"/>
            </a:xfrm>
            <a:custGeom>
              <a:avLst/>
              <a:gdLst>
                <a:gd name="connsiteX0" fmla="*/ 4425351 w 4425351"/>
                <a:gd name="connsiteY0" fmla="*/ 0 h 3554083"/>
                <a:gd name="connsiteX1" fmla="*/ 3631721 w 4425351"/>
                <a:gd name="connsiteY1" fmla="*/ 741872 h 3554083"/>
                <a:gd name="connsiteX2" fmla="*/ 3122763 w 4425351"/>
                <a:gd name="connsiteY2" fmla="*/ 715993 h 3554083"/>
                <a:gd name="connsiteX3" fmla="*/ 3019246 w 4425351"/>
                <a:gd name="connsiteY3" fmla="*/ 966159 h 3554083"/>
                <a:gd name="connsiteX4" fmla="*/ 2734574 w 4425351"/>
                <a:gd name="connsiteY4" fmla="*/ 1682151 h 3554083"/>
                <a:gd name="connsiteX5" fmla="*/ 2311880 w 4425351"/>
                <a:gd name="connsiteY5" fmla="*/ 1889185 h 3554083"/>
                <a:gd name="connsiteX6" fmla="*/ 1871932 w 4425351"/>
                <a:gd name="connsiteY6" fmla="*/ 1595887 h 3554083"/>
                <a:gd name="connsiteX7" fmla="*/ 1431985 w 4425351"/>
                <a:gd name="connsiteY7" fmla="*/ 1742536 h 3554083"/>
                <a:gd name="connsiteX8" fmla="*/ 0 w 4425351"/>
                <a:gd name="connsiteY8" fmla="*/ 3554083 h 3554083"/>
                <a:gd name="connsiteX9" fmla="*/ 0 w 4425351"/>
                <a:gd name="connsiteY9" fmla="*/ 3554083 h 3554083"/>
                <a:gd name="connsiteX0" fmla="*/ 4511064 w 4511064"/>
                <a:gd name="connsiteY0" fmla="*/ 0 h 3679950"/>
                <a:gd name="connsiteX1" fmla="*/ 3717434 w 4511064"/>
                <a:gd name="connsiteY1" fmla="*/ 741872 h 3679950"/>
                <a:gd name="connsiteX2" fmla="*/ 3208476 w 4511064"/>
                <a:gd name="connsiteY2" fmla="*/ 715993 h 3679950"/>
                <a:gd name="connsiteX3" fmla="*/ 3104959 w 4511064"/>
                <a:gd name="connsiteY3" fmla="*/ 966159 h 3679950"/>
                <a:gd name="connsiteX4" fmla="*/ 2820287 w 4511064"/>
                <a:gd name="connsiteY4" fmla="*/ 1682151 h 3679950"/>
                <a:gd name="connsiteX5" fmla="*/ 2397593 w 4511064"/>
                <a:gd name="connsiteY5" fmla="*/ 1889185 h 3679950"/>
                <a:gd name="connsiteX6" fmla="*/ 1957645 w 4511064"/>
                <a:gd name="connsiteY6" fmla="*/ 1595887 h 3679950"/>
                <a:gd name="connsiteX7" fmla="*/ 1517698 w 4511064"/>
                <a:gd name="connsiteY7" fmla="*/ 1742536 h 3679950"/>
                <a:gd name="connsiteX8" fmla="*/ 85713 w 4511064"/>
                <a:gd name="connsiteY8" fmla="*/ 3554083 h 3679950"/>
                <a:gd name="connsiteX9" fmla="*/ 173529 w 4511064"/>
                <a:gd name="connsiteY9" fmla="*/ 3520851 h 3679950"/>
                <a:gd name="connsiteX0" fmla="*/ 4425351 w 4425351"/>
                <a:gd name="connsiteY0" fmla="*/ 0 h 3554083"/>
                <a:gd name="connsiteX1" fmla="*/ 3631721 w 4425351"/>
                <a:gd name="connsiteY1" fmla="*/ 741872 h 3554083"/>
                <a:gd name="connsiteX2" fmla="*/ 3122763 w 4425351"/>
                <a:gd name="connsiteY2" fmla="*/ 715993 h 3554083"/>
                <a:gd name="connsiteX3" fmla="*/ 3019246 w 4425351"/>
                <a:gd name="connsiteY3" fmla="*/ 966159 h 3554083"/>
                <a:gd name="connsiteX4" fmla="*/ 2734574 w 4425351"/>
                <a:gd name="connsiteY4" fmla="*/ 1682151 h 3554083"/>
                <a:gd name="connsiteX5" fmla="*/ 2311880 w 4425351"/>
                <a:gd name="connsiteY5" fmla="*/ 1889185 h 3554083"/>
                <a:gd name="connsiteX6" fmla="*/ 1871932 w 4425351"/>
                <a:gd name="connsiteY6" fmla="*/ 1595887 h 3554083"/>
                <a:gd name="connsiteX7" fmla="*/ 1431985 w 4425351"/>
                <a:gd name="connsiteY7" fmla="*/ 1742536 h 3554083"/>
                <a:gd name="connsiteX8" fmla="*/ 0 w 4425351"/>
                <a:gd name="connsiteY8" fmla="*/ 3554083 h 3554083"/>
                <a:gd name="connsiteX0" fmla="*/ 2993367 w 2993367"/>
                <a:gd name="connsiteY0" fmla="*/ 0 h 1891074"/>
                <a:gd name="connsiteX1" fmla="*/ 2199737 w 2993367"/>
                <a:gd name="connsiteY1" fmla="*/ 741872 h 1891074"/>
                <a:gd name="connsiteX2" fmla="*/ 1690779 w 2993367"/>
                <a:gd name="connsiteY2" fmla="*/ 715993 h 1891074"/>
                <a:gd name="connsiteX3" fmla="*/ 1587262 w 2993367"/>
                <a:gd name="connsiteY3" fmla="*/ 966159 h 1891074"/>
                <a:gd name="connsiteX4" fmla="*/ 1302590 w 2993367"/>
                <a:gd name="connsiteY4" fmla="*/ 1682151 h 1891074"/>
                <a:gd name="connsiteX5" fmla="*/ 879896 w 2993367"/>
                <a:gd name="connsiteY5" fmla="*/ 1889185 h 1891074"/>
                <a:gd name="connsiteX6" fmla="*/ 439948 w 2993367"/>
                <a:gd name="connsiteY6" fmla="*/ 1595887 h 1891074"/>
                <a:gd name="connsiteX7" fmla="*/ 1 w 2993367"/>
                <a:gd name="connsiteY7" fmla="*/ 1742536 h 1891074"/>
                <a:gd name="connsiteX0" fmla="*/ 3025286 w 3025286"/>
                <a:gd name="connsiteY0" fmla="*/ 0 h 1891074"/>
                <a:gd name="connsiteX1" fmla="*/ 2231656 w 3025286"/>
                <a:gd name="connsiteY1" fmla="*/ 741872 h 1891074"/>
                <a:gd name="connsiteX2" fmla="*/ 1722698 w 3025286"/>
                <a:gd name="connsiteY2" fmla="*/ 715993 h 1891074"/>
                <a:gd name="connsiteX3" fmla="*/ 1619181 w 3025286"/>
                <a:gd name="connsiteY3" fmla="*/ 966159 h 1891074"/>
                <a:gd name="connsiteX4" fmla="*/ 1334509 w 3025286"/>
                <a:gd name="connsiteY4" fmla="*/ 1682151 h 1891074"/>
                <a:gd name="connsiteX5" fmla="*/ 911815 w 3025286"/>
                <a:gd name="connsiteY5" fmla="*/ 1889185 h 1891074"/>
                <a:gd name="connsiteX6" fmla="*/ 471867 w 3025286"/>
                <a:gd name="connsiteY6" fmla="*/ 1595887 h 1891074"/>
                <a:gd name="connsiteX7" fmla="*/ 31920 w 3025286"/>
                <a:gd name="connsiteY7" fmla="*/ 1742536 h 1891074"/>
                <a:gd name="connsiteX8" fmla="*/ 34276 w 3025286"/>
                <a:gd name="connsiteY8" fmla="*/ 1726253 h 1891074"/>
                <a:gd name="connsiteX0" fmla="*/ 4630252 w 4630252"/>
                <a:gd name="connsiteY0" fmla="*/ 0 h 2723264"/>
                <a:gd name="connsiteX1" fmla="*/ 3836622 w 4630252"/>
                <a:gd name="connsiteY1" fmla="*/ 741872 h 2723264"/>
                <a:gd name="connsiteX2" fmla="*/ 3327664 w 4630252"/>
                <a:gd name="connsiteY2" fmla="*/ 715993 h 2723264"/>
                <a:gd name="connsiteX3" fmla="*/ 3224147 w 4630252"/>
                <a:gd name="connsiteY3" fmla="*/ 966159 h 2723264"/>
                <a:gd name="connsiteX4" fmla="*/ 2939475 w 4630252"/>
                <a:gd name="connsiteY4" fmla="*/ 1682151 h 2723264"/>
                <a:gd name="connsiteX5" fmla="*/ 2516781 w 4630252"/>
                <a:gd name="connsiteY5" fmla="*/ 1889185 h 2723264"/>
                <a:gd name="connsiteX6" fmla="*/ 2076833 w 4630252"/>
                <a:gd name="connsiteY6" fmla="*/ 1595887 h 2723264"/>
                <a:gd name="connsiteX7" fmla="*/ 1636886 w 4630252"/>
                <a:gd name="connsiteY7" fmla="*/ 1742536 h 2723264"/>
                <a:gd name="connsiteX8" fmla="*/ 0 w 4630252"/>
                <a:gd name="connsiteY8" fmla="*/ 2723254 h 2723264"/>
                <a:gd name="connsiteX0" fmla="*/ 5912428 w 5912428"/>
                <a:gd name="connsiteY0" fmla="*/ 0 h 3246296"/>
                <a:gd name="connsiteX1" fmla="*/ 5118798 w 5912428"/>
                <a:gd name="connsiteY1" fmla="*/ 741872 h 3246296"/>
                <a:gd name="connsiteX2" fmla="*/ 4609840 w 5912428"/>
                <a:gd name="connsiteY2" fmla="*/ 715993 h 3246296"/>
                <a:gd name="connsiteX3" fmla="*/ 4506323 w 5912428"/>
                <a:gd name="connsiteY3" fmla="*/ 966159 h 3246296"/>
                <a:gd name="connsiteX4" fmla="*/ 4221651 w 5912428"/>
                <a:gd name="connsiteY4" fmla="*/ 1682151 h 3246296"/>
                <a:gd name="connsiteX5" fmla="*/ 3798957 w 5912428"/>
                <a:gd name="connsiteY5" fmla="*/ 1889185 h 3246296"/>
                <a:gd name="connsiteX6" fmla="*/ 3359009 w 5912428"/>
                <a:gd name="connsiteY6" fmla="*/ 1595887 h 3246296"/>
                <a:gd name="connsiteX7" fmla="*/ 2919062 w 5912428"/>
                <a:gd name="connsiteY7" fmla="*/ 1742536 h 3246296"/>
                <a:gd name="connsiteX8" fmla="*/ 0 w 5912428"/>
                <a:gd name="connsiteY8" fmla="*/ 3246288 h 324629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5912428" h="3246296">
                  <a:moveTo>
                    <a:pt x="5912428" y="0"/>
                  </a:moveTo>
                  <a:cubicBezTo>
                    <a:pt x="5624162" y="311270"/>
                    <a:pt x="5335896" y="622540"/>
                    <a:pt x="5118798" y="741872"/>
                  </a:cubicBezTo>
                  <a:cubicBezTo>
                    <a:pt x="4901700" y="861204"/>
                    <a:pt x="4711919" y="678612"/>
                    <a:pt x="4609840" y="715993"/>
                  </a:cubicBezTo>
                  <a:cubicBezTo>
                    <a:pt x="4507761" y="753374"/>
                    <a:pt x="4571021" y="805133"/>
                    <a:pt x="4506323" y="966159"/>
                  </a:cubicBezTo>
                  <a:cubicBezTo>
                    <a:pt x="4441625" y="1127185"/>
                    <a:pt x="4339545" y="1528313"/>
                    <a:pt x="4221651" y="1682151"/>
                  </a:cubicBezTo>
                  <a:cubicBezTo>
                    <a:pt x="4103757" y="1835989"/>
                    <a:pt x="3942731" y="1903562"/>
                    <a:pt x="3798957" y="1889185"/>
                  </a:cubicBezTo>
                  <a:cubicBezTo>
                    <a:pt x="3655183" y="1874808"/>
                    <a:pt x="3505658" y="1620328"/>
                    <a:pt x="3359009" y="1595887"/>
                  </a:cubicBezTo>
                  <a:cubicBezTo>
                    <a:pt x="3212360" y="1571446"/>
                    <a:pt x="3265201" y="1554642"/>
                    <a:pt x="2919062" y="1742536"/>
                  </a:cubicBezTo>
                  <a:cubicBezTo>
                    <a:pt x="2572923" y="1930431"/>
                    <a:pt x="-491" y="3249680"/>
                    <a:pt x="0" y="3246288"/>
                  </a:cubicBezTo>
                </a:path>
              </a:pathLst>
            </a:cu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5" name="Left Arrow 15">
              <a:extLst>
                <a:ext uri="{FF2B5EF4-FFF2-40B4-BE49-F238E27FC236}">
                  <a16:creationId xmlns:a16="http://schemas.microsoft.com/office/drawing/2014/main" id="{16DBE1F1-9E2D-71D2-FD74-1371DC62312E}"/>
                </a:ext>
              </a:extLst>
            </p:cNvPr>
            <p:cNvSpPr/>
            <p:nvPr/>
          </p:nvSpPr>
          <p:spPr>
            <a:xfrm rot="17880236">
              <a:off x="4797879" y="1099324"/>
              <a:ext cx="339415" cy="436604"/>
            </a:xfrm>
            <a:prstGeom prst="leftArrow">
              <a:avLst>
                <a:gd name="adj1" fmla="val 47938"/>
                <a:gd name="adj2" fmla="val 50000"/>
              </a:avLst>
            </a:prstGeom>
            <a:solidFill>
              <a:schemeClr val="bg1">
                <a:lumMod val="95000"/>
              </a:schemeClr>
            </a:solidFill>
            <a:ln>
              <a:solidFill>
                <a:schemeClr val="bg1">
                  <a:lumMod val="95000"/>
                  <a:alpha val="19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" name="Down Arrow 17">
              <a:extLst>
                <a:ext uri="{FF2B5EF4-FFF2-40B4-BE49-F238E27FC236}">
                  <a16:creationId xmlns:a16="http://schemas.microsoft.com/office/drawing/2014/main" id="{235FD127-CE0F-6193-ECCC-7F9C874510CA}"/>
                </a:ext>
              </a:extLst>
            </p:cNvPr>
            <p:cNvSpPr/>
            <p:nvPr/>
          </p:nvSpPr>
          <p:spPr>
            <a:xfrm rot="3824345">
              <a:off x="5715564" y="446221"/>
              <a:ext cx="178124" cy="249898"/>
            </a:xfrm>
            <a:prstGeom prst="downArrow">
              <a:avLst/>
            </a:prstGeom>
            <a:solidFill>
              <a:schemeClr val="tx1">
                <a:lumMod val="75000"/>
                <a:lumOff val="25000"/>
              </a:schemeClr>
            </a:solidFill>
            <a:ln w="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57" name="Freeform 21">
              <a:extLst>
                <a:ext uri="{FF2B5EF4-FFF2-40B4-BE49-F238E27FC236}">
                  <a16:creationId xmlns:a16="http://schemas.microsoft.com/office/drawing/2014/main" id="{B1CBBBE9-8B1C-415C-26D3-FE1D61FF71E3}"/>
                </a:ext>
              </a:extLst>
            </p:cNvPr>
            <p:cNvSpPr/>
            <p:nvPr/>
          </p:nvSpPr>
          <p:spPr>
            <a:xfrm>
              <a:off x="4051859" y="1028089"/>
              <a:ext cx="384725" cy="748044"/>
            </a:xfrm>
            <a:custGeom>
              <a:avLst/>
              <a:gdLst>
                <a:gd name="connsiteX0" fmla="*/ 838792 w 1012433"/>
                <a:gd name="connsiteY0" fmla="*/ 1968536 h 1968536"/>
                <a:gd name="connsiteX1" fmla="*/ 999566 w 1012433"/>
                <a:gd name="connsiteY1" fmla="*/ 1305345 h 1968536"/>
                <a:gd name="connsiteX2" fmla="*/ 899082 w 1012433"/>
                <a:gd name="connsiteY2" fmla="*/ 772782 h 1968536"/>
                <a:gd name="connsiteX3" fmla="*/ 85166 w 1012433"/>
                <a:gd name="connsiteY3" fmla="*/ 179929 h 1968536"/>
                <a:gd name="connsiteX4" fmla="*/ 24876 w 1012433"/>
                <a:gd name="connsiteY4" fmla="*/ 19156 h 1968536"/>
                <a:gd name="connsiteX5" fmla="*/ 14828 w 1012433"/>
                <a:gd name="connsiteY5" fmla="*/ 9107 h 19685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1012433" h="1968536">
                  <a:moveTo>
                    <a:pt x="838792" y="1968536"/>
                  </a:moveTo>
                  <a:cubicBezTo>
                    <a:pt x="914155" y="1736586"/>
                    <a:pt x="989518" y="1504637"/>
                    <a:pt x="999566" y="1305345"/>
                  </a:cubicBezTo>
                  <a:cubicBezTo>
                    <a:pt x="1009614" y="1106053"/>
                    <a:pt x="1051482" y="960351"/>
                    <a:pt x="899082" y="772782"/>
                  </a:cubicBezTo>
                  <a:cubicBezTo>
                    <a:pt x="746682" y="585213"/>
                    <a:pt x="230867" y="305533"/>
                    <a:pt x="85166" y="179929"/>
                  </a:cubicBezTo>
                  <a:cubicBezTo>
                    <a:pt x="-60535" y="54325"/>
                    <a:pt x="24876" y="19156"/>
                    <a:pt x="24876" y="19156"/>
                  </a:cubicBezTo>
                  <a:cubicBezTo>
                    <a:pt x="13153" y="-9314"/>
                    <a:pt x="13990" y="-104"/>
                    <a:pt x="14828" y="9107"/>
                  </a:cubicBezTo>
                </a:path>
              </a:pathLst>
            </a:custGeom>
            <a:solidFill>
              <a:schemeClr val="bg1"/>
            </a:solidFill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8" name="Freeform 22">
              <a:extLst>
                <a:ext uri="{FF2B5EF4-FFF2-40B4-BE49-F238E27FC236}">
                  <a16:creationId xmlns:a16="http://schemas.microsoft.com/office/drawing/2014/main" id="{0A8A69E5-E694-6AD0-505E-6C48E90F1E50}"/>
                </a:ext>
              </a:extLst>
            </p:cNvPr>
            <p:cNvSpPr/>
            <p:nvPr/>
          </p:nvSpPr>
          <p:spPr>
            <a:xfrm>
              <a:off x="4412602" y="1357367"/>
              <a:ext cx="465842" cy="277487"/>
            </a:xfrm>
            <a:custGeom>
              <a:avLst/>
              <a:gdLst>
                <a:gd name="connsiteX0" fmla="*/ 0 w 1225899"/>
                <a:gd name="connsiteY0" fmla="*/ 730228 h 730228"/>
                <a:gd name="connsiteX1" fmla="*/ 351693 w 1225899"/>
                <a:gd name="connsiteY1" fmla="*/ 338342 h 730228"/>
                <a:gd name="connsiteX2" fmla="*/ 1024932 w 1225899"/>
                <a:gd name="connsiteY2" fmla="*/ 6746 h 730228"/>
                <a:gd name="connsiteX3" fmla="*/ 1225899 w 1225899"/>
                <a:gd name="connsiteY3" fmla="*/ 107230 h 730228"/>
                <a:gd name="connsiteX4" fmla="*/ 1225899 w 1225899"/>
                <a:gd name="connsiteY4" fmla="*/ 107230 h 730228"/>
                <a:gd name="connsiteX5" fmla="*/ 1225899 w 1225899"/>
                <a:gd name="connsiteY5" fmla="*/ 107230 h 730228"/>
                <a:gd name="connsiteX6" fmla="*/ 1225899 w 1225899"/>
                <a:gd name="connsiteY6" fmla="*/ 107230 h 730228"/>
                <a:gd name="connsiteX7" fmla="*/ 1225899 w 1225899"/>
                <a:gd name="connsiteY7" fmla="*/ 107230 h 7302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1225899" h="730228">
                  <a:moveTo>
                    <a:pt x="0" y="730228"/>
                  </a:moveTo>
                  <a:cubicBezTo>
                    <a:pt x="90435" y="594575"/>
                    <a:pt x="180871" y="458922"/>
                    <a:pt x="351693" y="338342"/>
                  </a:cubicBezTo>
                  <a:cubicBezTo>
                    <a:pt x="522515" y="217762"/>
                    <a:pt x="879231" y="45265"/>
                    <a:pt x="1024932" y="6746"/>
                  </a:cubicBezTo>
                  <a:cubicBezTo>
                    <a:pt x="1170633" y="-31773"/>
                    <a:pt x="1225899" y="107230"/>
                    <a:pt x="1225899" y="107230"/>
                  </a:cubicBezTo>
                  <a:lnTo>
                    <a:pt x="1225899" y="107230"/>
                  </a:lnTo>
                  <a:lnTo>
                    <a:pt x="1225899" y="107230"/>
                  </a:lnTo>
                  <a:lnTo>
                    <a:pt x="1225899" y="107230"/>
                  </a:lnTo>
                  <a:lnTo>
                    <a:pt x="1225899" y="107230"/>
                  </a:lnTo>
                </a:path>
              </a:pathLst>
            </a:custGeom>
            <a:noFill/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Freeform 23">
              <a:extLst>
                <a:ext uri="{FF2B5EF4-FFF2-40B4-BE49-F238E27FC236}">
                  <a16:creationId xmlns:a16="http://schemas.microsoft.com/office/drawing/2014/main" id="{2DC1C176-0002-E4CF-715A-94C64A932CF6}"/>
                </a:ext>
              </a:extLst>
            </p:cNvPr>
            <p:cNvSpPr/>
            <p:nvPr/>
          </p:nvSpPr>
          <p:spPr>
            <a:xfrm>
              <a:off x="3851301" y="1222469"/>
              <a:ext cx="530754" cy="72549"/>
            </a:xfrm>
            <a:custGeom>
              <a:avLst/>
              <a:gdLst>
                <a:gd name="connsiteX0" fmla="*/ 1396720 w 1396720"/>
                <a:gd name="connsiteY0" fmla="*/ 190919 h 190919"/>
                <a:gd name="connsiteX1" fmla="*/ 653142 w 1396720"/>
                <a:gd name="connsiteY1" fmla="*/ 110532 h 190919"/>
                <a:gd name="connsiteX2" fmla="*/ 0 w 1396720"/>
                <a:gd name="connsiteY2" fmla="*/ 0 h 1909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396720" h="190919">
                  <a:moveTo>
                    <a:pt x="1396720" y="190919"/>
                  </a:moveTo>
                  <a:cubicBezTo>
                    <a:pt x="1141324" y="166635"/>
                    <a:pt x="885929" y="142352"/>
                    <a:pt x="653142" y="110532"/>
                  </a:cubicBezTo>
                  <a:cubicBezTo>
                    <a:pt x="420355" y="78712"/>
                    <a:pt x="210177" y="39356"/>
                    <a:pt x="0" y="0"/>
                  </a:cubicBezTo>
                </a:path>
              </a:pathLst>
            </a:custGeom>
            <a:solidFill>
              <a:schemeClr val="bg1"/>
            </a:solidFill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0" name="Freeform 24">
              <a:extLst>
                <a:ext uri="{FF2B5EF4-FFF2-40B4-BE49-F238E27FC236}">
                  <a16:creationId xmlns:a16="http://schemas.microsoft.com/office/drawing/2014/main" id="{1EC1EC6D-44D9-CB03-2BA0-4AB593F03241}"/>
                </a:ext>
              </a:extLst>
            </p:cNvPr>
            <p:cNvSpPr/>
            <p:nvPr/>
          </p:nvSpPr>
          <p:spPr>
            <a:xfrm>
              <a:off x="4338949" y="917065"/>
              <a:ext cx="146202" cy="377954"/>
            </a:xfrm>
            <a:custGeom>
              <a:avLst/>
              <a:gdLst>
                <a:gd name="connsiteX0" fmla="*/ 103387 w 384741"/>
                <a:gd name="connsiteY0" fmla="*/ 994615 h 994615"/>
                <a:gd name="connsiteX1" fmla="*/ 2904 w 384741"/>
                <a:gd name="connsiteY1" fmla="*/ 341472 h 994615"/>
                <a:gd name="connsiteX2" fmla="*/ 203871 w 384741"/>
                <a:gd name="connsiteY2" fmla="*/ 29973 h 994615"/>
                <a:gd name="connsiteX3" fmla="*/ 384741 w 384741"/>
                <a:gd name="connsiteY3" fmla="*/ 29973 h 99461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384741" h="994615">
                  <a:moveTo>
                    <a:pt x="103387" y="994615"/>
                  </a:moveTo>
                  <a:cubicBezTo>
                    <a:pt x="44772" y="748430"/>
                    <a:pt x="-13843" y="502246"/>
                    <a:pt x="2904" y="341472"/>
                  </a:cubicBezTo>
                  <a:cubicBezTo>
                    <a:pt x="19651" y="180698"/>
                    <a:pt x="140232" y="81889"/>
                    <a:pt x="203871" y="29973"/>
                  </a:cubicBezTo>
                  <a:cubicBezTo>
                    <a:pt x="267510" y="-21943"/>
                    <a:pt x="326125" y="4015"/>
                    <a:pt x="384741" y="29973"/>
                  </a:cubicBezTo>
                </a:path>
              </a:pathLst>
            </a:custGeom>
            <a:noFill/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1" name="Freeform 25">
              <a:extLst>
                <a:ext uri="{FF2B5EF4-FFF2-40B4-BE49-F238E27FC236}">
                  <a16:creationId xmlns:a16="http://schemas.microsoft.com/office/drawing/2014/main" id="{0085A619-3B78-07FF-DF51-23416D20CE38}"/>
                </a:ext>
              </a:extLst>
            </p:cNvPr>
            <p:cNvSpPr/>
            <p:nvPr/>
          </p:nvSpPr>
          <p:spPr>
            <a:xfrm>
              <a:off x="4607339" y="1169012"/>
              <a:ext cx="77165" cy="274923"/>
            </a:xfrm>
            <a:custGeom>
              <a:avLst/>
              <a:gdLst>
                <a:gd name="connsiteX0" fmla="*/ 0 w 203066"/>
                <a:gd name="connsiteY0" fmla="*/ 723481 h 723481"/>
                <a:gd name="connsiteX1" fmla="*/ 200967 w 203066"/>
                <a:gd name="connsiteY1" fmla="*/ 311499 h 723481"/>
                <a:gd name="connsiteX2" fmla="*/ 110532 w 203066"/>
                <a:gd name="connsiteY2" fmla="*/ 0 h 723481"/>
                <a:gd name="connsiteX3" fmla="*/ 110532 w 203066"/>
                <a:gd name="connsiteY3" fmla="*/ 0 h 72348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203066" h="723481">
                  <a:moveTo>
                    <a:pt x="0" y="723481"/>
                  </a:moveTo>
                  <a:cubicBezTo>
                    <a:pt x="91272" y="577780"/>
                    <a:pt x="182545" y="432079"/>
                    <a:pt x="200967" y="311499"/>
                  </a:cubicBezTo>
                  <a:cubicBezTo>
                    <a:pt x="219389" y="190919"/>
                    <a:pt x="110532" y="0"/>
                    <a:pt x="110532" y="0"/>
                  </a:cubicBezTo>
                  <a:lnTo>
                    <a:pt x="110532" y="0"/>
                  </a:ln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2" name="Freeform 26">
              <a:extLst>
                <a:ext uri="{FF2B5EF4-FFF2-40B4-BE49-F238E27FC236}">
                  <a16:creationId xmlns:a16="http://schemas.microsoft.com/office/drawing/2014/main" id="{CE428633-1515-DDBB-E944-A0D1688A8336}"/>
                </a:ext>
              </a:extLst>
            </p:cNvPr>
            <p:cNvSpPr/>
            <p:nvPr/>
          </p:nvSpPr>
          <p:spPr>
            <a:xfrm>
              <a:off x="4542426" y="1505029"/>
              <a:ext cx="454387" cy="84104"/>
            </a:xfrm>
            <a:custGeom>
              <a:avLst/>
              <a:gdLst>
                <a:gd name="connsiteX0" fmla="*/ 0 w 1195754"/>
                <a:gd name="connsiteY0" fmla="*/ 0 h 221326"/>
                <a:gd name="connsiteX1" fmla="*/ 442128 w 1195754"/>
                <a:gd name="connsiteY1" fmla="*/ 60290 h 221326"/>
                <a:gd name="connsiteX2" fmla="*/ 1014884 w 1195754"/>
                <a:gd name="connsiteY2" fmla="*/ 221064 h 221326"/>
                <a:gd name="connsiteX3" fmla="*/ 1195754 w 1195754"/>
                <a:gd name="connsiteY3" fmla="*/ 90435 h 2213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195754" h="221326">
                  <a:moveTo>
                    <a:pt x="0" y="0"/>
                  </a:moveTo>
                  <a:cubicBezTo>
                    <a:pt x="136490" y="11723"/>
                    <a:pt x="272981" y="23446"/>
                    <a:pt x="442128" y="60290"/>
                  </a:cubicBezTo>
                  <a:cubicBezTo>
                    <a:pt x="611275" y="97134"/>
                    <a:pt x="889280" y="216040"/>
                    <a:pt x="1014884" y="221064"/>
                  </a:cubicBezTo>
                  <a:cubicBezTo>
                    <a:pt x="1140488" y="226088"/>
                    <a:pt x="1168121" y="158261"/>
                    <a:pt x="1195754" y="90435"/>
                  </a:cubicBezTo>
                </a:path>
              </a:pathLst>
            </a:custGeom>
            <a:noFill/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3" name="Freeform 27">
              <a:extLst>
                <a:ext uri="{FF2B5EF4-FFF2-40B4-BE49-F238E27FC236}">
                  <a16:creationId xmlns:a16="http://schemas.microsoft.com/office/drawing/2014/main" id="{96780E49-921D-EABB-F42D-7DED23626DBB}"/>
                </a:ext>
              </a:extLst>
            </p:cNvPr>
            <p:cNvSpPr/>
            <p:nvPr/>
          </p:nvSpPr>
          <p:spPr>
            <a:xfrm>
              <a:off x="4427875" y="1081189"/>
              <a:ext cx="141740" cy="286378"/>
            </a:xfrm>
            <a:custGeom>
              <a:avLst/>
              <a:gdLst>
                <a:gd name="connsiteX0" fmla="*/ 0 w 372999"/>
                <a:gd name="connsiteY0" fmla="*/ 753626 h 753626"/>
                <a:gd name="connsiteX1" fmla="*/ 361740 w 372999"/>
                <a:gd name="connsiteY1" fmla="*/ 512466 h 753626"/>
                <a:gd name="connsiteX2" fmla="*/ 281353 w 372999"/>
                <a:gd name="connsiteY2" fmla="*/ 180870 h 753626"/>
                <a:gd name="connsiteX3" fmla="*/ 281353 w 372999"/>
                <a:gd name="connsiteY3" fmla="*/ 0 h 753626"/>
                <a:gd name="connsiteX4" fmla="*/ 281353 w 372999"/>
                <a:gd name="connsiteY4" fmla="*/ 0 h 7536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372999" h="753626">
                  <a:moveTo>
                    <a:pt x="0" y="753626"/>
                  </a:moveTo>
                  <a:cubicBezTo>
                    <a:pt x="157424" y="680775"/>
                    <a:pt x="314848" y="607925"/>
                    <a:pt x="361740" y="512466"/>
                  </a:cubicBezTo>
                  <a:cubicBezTo>
                    <a:pt x="408632" y="417007"/>
                    <a:pt x="294751" y="266281"/>
                    <a:pt x="281353" y="180870"/>
                  </a:cubicBezTo>
                  <a:cubicBezTo>
                    <a:pt x="267955" y="95459"/>
                    <a:pt x="281353" y="0"/>
                    <a:pt x="281353" y="0"/>
                  </a:cubicBezTo>
                  <a:lnTo>
                    <a:pt x="281353" y="0"/>
                  </a:ln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4" name="Freeform 28">
              <a:extLst>
                <a:ext uri="{FF2B5EF4-FFF2-40B4-BE49-F238E27FC236}">
                  <a16:creationId xmlns:a16="http://schemas.microsoft.com/office/drawing/2014/main" id="{D8263CE2-2BCC-AB8B-E9B9-CF923C81AEE8}"/>
                </a:ext>
              </a:extLst>
            </p:cNvPr>
            <p:cNvSpPr/>
            <p:nvPr/>
          </p:nvSpPr>
          <p:spPr>
            <a:xfrm>
              <a:off x="4202591" y="867360"/>
              <a:ext cx="141280" cy="145098"/>
            </a:xfrm>
            <a:custGeom>
              <a:avLst/>
              <a:gdLst>
                <a:gd name="connsiteX0" fmla="*/ 371789 w 371789"/>
                <a:gd name="connsiteY0" fmla="*/ 381837 h 381837"/>
                <a:gd name="connsiteX1" fmla="*/ 261257 w 371789"/>
                <a:gd name="connsiteY1" fmla="*/ 150725 h 381837"/>
                <a:gd name="connsiteX2" fmla="*/ 0 w 371789"/>
                <a:gd name="connsiteY2" fmla="*/ 0 h 38183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71789" h="381837">
                  <a:moveTo>
                    <a:pt x="371789" y="381837"/>
                  </a:moveTo>
                  <a:cubicBezTo>
                    <a:pt x="347505" y="298100"/>
                    <a:pt x="323222" y="214364"/>
                    <a:pt x="261257" y="150725"/>
                  </a:cubicBezTo>
                  <a:cubicBezTo>
                    <a:pt x="199292" y="87086"/>
                    <a:pt x="99646" y="43543"/>
                    <a:pt x="0" y="0"/>
                  </a:cubicBezTo>
                </a:path>
              </a:pathLst>
            </a:custGeom>
            <a:solidFill>
              <a:schemeClr val="bg1"/>
            </a:solidFill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5" name="Freeform 30">
              <a:extLst>
                <a:ext uri="{FF2B5EF4-FFF2-40B4-BE49-F238E27FC236}">
                  <a16:creationId xmlns:a16="http://schemas.microsoft.com/office/drawing/2014/main" id="{1331F7F8-248F-67A1-98E2-14C3818D6042}"/>
                </a:ext>
              </a:extLst>
            </p:cNvPr>
            <p:cNvSpPr/>
            <p:nvPr/>
          </p:nvSpPr>
          <p:spPr>
            <a:xfrm>
              <a:off x="4138645" y="1272993"/>
              <a:ext cx="299254" cy="286378"/>
            </a:xfrm>
            <a:custGeom>
              <a:avLst/>
              <a:gdLst>
                <a:gd name="connsiteX0" fmla="*/ 773723 w 785397"/>
                <a:gd name="connsiteY0" fmla="*/ 753626 h 753626"/>
                <a:gd name="connsiteX1" fmla="*/ 783771 w 785397"/>
                <a:gd name="connsiteY1" fmla="*/ 432079 h 753626"/>
                <a:gd name="connsiteX2" fmla="*/ 743578 w 785397"/>
                <a:gd name="connsiteY2" fmla="*/ 211016 h 753626"/>
                <a:gd name="connsiteX3" fmla="*/ 643094 w 785397"/>
                <a:gd name="connsiteY3" fmla="*/ 70339 h 753626"/>
                <a:gd name="connsiteX4" fmla="*/ 371789 w 785397"/>
                <a:gd name="connsiteY4" fmla="*/ 50242 h 753626"/>
                <a:gd name="connsiteX5" fmla="*/ 0 w 785397"/>
                <a:gd name="connsiteY5" fmla="*/ 0 h 753626"/>
                <a:gd name="connsiteX6" fmla="*/ 0 w 785397"/>
                <a:gd name="connsiteY6" fmla="*/ 0 h 753626"/>
                <a:gd name="connsiteX0" fmla="*/ 773723 w 785397"/>
                <a:gd name="connsiteY0" fmla="*/ 753626 h 753626"/>
                <a:gd name="connsiteX1" fmla="*/ 783771 w 785397"/>
                <a:gd name="connsiteY1" fmla="*/ 432079 h 753626"/>
                <a:gd name="connsiteX2" fmla="*/ 743578 w 785397"/>
                <a:gd name="connsiteY2" fmla="*/ 211016 h 753626"/>
                <a:gd name="connsiteX3" fmla="*/ 643094 w 785397"/>
                <a:gd name="connsiteY3" fmla="*/ 70339 h 753626"/>
                <a:gd name="connsiteX4" fmla="*/ 371789 w 785397"/>
                <a:gd name="connsiteY4" fmla="*/ 20097 h 753626"/>
                <a:gd name="connsiteX5" fmla="*/ 0 w 785397"/>
                <a:gd name="connsiteY5" fmla="*/ 0 h 753626"/>
                <a:gd name="connsiteX6" fmla="*/ 0 w 785397"/>
                <a:gd name="connsiteY6" fmla="*/ 0 h 753626"/>
                <a:gd name="connsiteX0" fmla="*/ 773723 w 785397"/>
                <a:gd name="connsiteY0" fmla="*/ 753626 h 753626"/>
                <a:gd name="connsiteX1" fmla="*/ 783771 w 785397"/>
                <a:gd name="connsiteY1" fmla="*/ 432079 h 753626"/>
                <a:gd name="connsiteX2" fmla="*/ 743578 w 785397"/>
                <a:gd name="connsiteY2" fmla="*/ 211016 h 753626"/>
                <a:gd name="connsiteX3" fmla="*/ 643094 w 785397"/>
                <a:gd name="connsiteY3" fmla="*/ 100484 h 753626"/>
                <a:gd name="connsiteX4" fmla="*/ 371789 w 785397"/>
                <a:gd name="connsiteY4" fmla="*/ 20097 h 753626"/>
                <a:gd name="connsiteX5" fmla="*/ 0 w 785397"/>
                <a:gd name="connsiteY5" fmla="*/ 0 h 753626"/>
                <a:gd name="connsiteX6" fmla="*/ 0 w 785397"/>
                <a:gd name="connsiteY6" fmla="*/ 0 h 753626"/>
                <a:gd name="connsiteX0" fmla="*/ 773723 w 787510"/>
                <a:gd name="connsiteY0" fmla="*/ 753626 h 753626"/>
                <a:gd name="connsiteX1" fmla="*/ 783771 w 787510"/>
                <a:gd name="connsiteY1" fmla="*/ 432079 h 753626"/>
                <a:gd name="connsiteX2" fmla="*/ 713433 w 787510"/>
                <a:gd name="connsiteY2" fmla="*/ 231113 h 753626"/>
                <a:gd name="connsiteX3" fmla="*/ 643094 w 787510"/>
                <a:gd name="connsiteY3" fmla="*/ 100484 h 753626"/>
                <a:gd name="connsiteX4" fmla="*/ 371789 w 787510"/>
                <a:gd name="connsiteY4" fmla="*/ 20097 h 753626"/>
                <a:gd name="connsiteX5" fmla="*/ 0 w 787510"/>
                <a:gd name="connsiteY5" fmla="*/ 0 h 753626"/>
                <a:gd name="connsiteX6" fmla="*/ 0 w 787510"/>
                <a:gd name="connsiteY6" fmla="*/ 0 h 753626"/>
                <a:gd name="connsiteX0" fmla="*/ 773723 w 787510"/>
                <a:gd name="connsiteY0" fmla="*/ 753626 h 753626"/>
                <a:gd name="connsiteX1" fmla="*/ 783771 w 787510"/>
                <a:gd name="connsiteY1" fmla="*/ 432079 h 753626"/>
                <a:gd name="connsiteX2" fmla="*/ 713433 w 787510"/>
                <a:gd name="connsiteY2" fmla="*/ 231113 h 753626"/>
                <a:gd name="connsiteX3" fmla="*/ 643094 w 787510"/>
                <a:gd name="connsiteY3" fmla="*/ 100484 h 753626"/>
                <a:gd name="connsiteX4" fmla="*/ 351692 w 787510"/>
                <a:gd name="connsiteY4" fmla="*/ 40193 h 753626"/>
                <a:gd name="connsiteX5" fmla="*/ 0 w 787510"/>
                <a:gd name="connsiteY5" fmla="*/ 0 h 753626"/>
                <a:gd name="connsiteX6" fmla="*/ 0 w 787510"/>
                <a:gd name="connsiteY6" fmla="*/ 0 h 7536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787510" h="753626">
                  <a:moveTo>
                    <a:pt x="773723" y="753626"/>
                  </a:moveTo>
                  <a:cubicBezTo>
                    <a:pt x="781259" y="638070"/>
                    <a:pt x="793819" y="519164"/>
                    <a:pt x="783771" y="432079"/>
                  </a:cubicBezTo>
                  <a:cubicBezTo>
                    <a:pt x="773723" y="344994"/>
                    <a:pt x="736879" y="286379"/>
                    <a:pt x="713433" y="231113"/>
                  </a:cubicBezTo>
                  <a:cubicBezTo>
                    <a:pt x="689987" y="175847"/>
                    <a:pt x="703384" y="132304"/>
                    <a:pt x="643094" y="100484"/>
                  </a:cubicBezTo>
                  <a:cubicBezTo>
                    <a:pt x="582804" y="68664"/>
                    <a:pt x="458874" y="56940"/>
                    <a:pt x="351692" y="40193"/>
                  </a:cubicBezTo>
                  <a:cubicBezTo>
                    <a:pt x="244510" y="23446"/>
                    <a:pt x="58615" y="6699"/>
                    <a:pt x="0" y="0"/>
                  </a:cubicBezTo>
                  <a:lnTo>
                    <a:pt x="0" y="0"/>
                  </a:ln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6" name="Freeform 31">
              <a:extLst>
                <a:ext uri="{FF2B5EF4-FFF2-40B4-BE49-F238E27FC236}">
                  <a16:creationId xmlns:a16="http://schemas.microsoft.com/office/drawing/2014/main" id="{77F7EEEC-1D22-770D-DC79-5E2DA15867F8}"/>
                </a:ext>
              </a:extLst>
            </p:cNvPr>
            <p:cNvSpPr/>
            <p:nvPr/>
          </p:nvSpPr>
          <p:spPr>
            <a:xfrm>
              <a:off x="4348655" y="1169897"/>
              <a:ext cx="38184" cy="141280"/>
            </a:xfrm>
            <a:custGeom>
              <a:avLst/>
              <a:gdLst>
                <a:gd name="connsiteX0" fmla="*/ 100484 w 100484"/>
                <a:gd name="connsiteY0" fmla="*/ 371789 h 371789"/>
                <a:gd name="connsiteX1" fmla="*/ 40194 w 100484"/>
                <a:gd name="connsiteY1" fmla="*/ 160773 h 371789"/>
                <a:gd name="connsiteX2" fmla="*/ 0 w 100484"/>
                <a:gd name="connsiteY2" fmla="*/ 0 h 371789"/>
                <a:gd name="connsiteX3" fmla="*/ 0 w 100484"/>
                <a:gd name="connsiteY3" fmla="*/ 0 h 3717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0484" h="371789">
                  <a:moveTo>
                    <a:pt x="100484" y="371789"/>
                  </a:moveTo>
                  <a:cubicBezTo>
                    <a:pt x="78712" y="297263"/>
                    <a:pt x="56941" y="222738"/>
                    <a:pt x="40194" y="160773"/>
                  </a:cubicBezTo>
                  <a:cubicBezTo>
                    <a:pt x="23447" y="98808"/>
                    <a:pt x="0" y="0"/>
                    <a:pt x="0" y="0"/>
                  </a:cubicBezTo>
                  <a:lnTo>
                    <a:pt x="0" y="0"/>
                  </a:lnTo>
                </a:path>
              </a:pathLst>
            </a:custGeom>
            <a:noFill/>
            <a:ln w="38100">
              <a:solidFill>
                <a:schemeClr val="bg1">
                  <a:lumMod val="8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" name="Freeform 32">
              <a:extLst>
                <a:ext uri="{FF2B5EF4-FFF2-40B4-BE49-F238E27FC236}">
                  <a16:creationId xmlns:a16="http://schemas.microsoft.com/office/drawing/2014/main" id="{DFF45430-FAB0-797B-2EE1-4695A73AAF34}"/>
                </a:ext>
              </a:extLst>
            </p:cNvPr>
            <p:cNvSpPr/>
            <p:nvPr/>
          </p:nvSpPr>
          <p:spPr>
            <a:xfrm>
              <a:off x="4241740" y="1208081"/>
              <a:ext cx="141280" cy="95459"/>
            </a:xfrm>
            <a:custGeom>
              <a:avLst/>
              <a:gdLst>
                <a:gd name="connsiteX0" fmla="*/ 371789 w 371789"/>
                <a:gd name="connsiteY0" fmla="*/ 251209 h 251209"/>
                <a:gd name="connsiteX1" fmla="*/ 0 w 371789"/>
                <a:gd name="connsiteY1" fmla="*/ 0 h 251209"/>
                <a:gd name="connsiteX2" fmla="*/ 0 w 371789"/>
                <a:gd name="connsiteY2" fmla="*/ 0 h 25120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71789" h="251209">
                  <a:moveTo>
                    <a:pt x="371789" y="25120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EF9E94E1-CDCF-B296-CBC9-487FEB22D8AA}"/>
                </a:ext>
              </a:extLst>
            </p:cNvPr>
            <p:cNvSpPr txBox="1"/>
            <p:nvPr/>
          </p:nvSpPr>
          <p:spPr>
            <a:xfrm rot="20057765">
              <a:off x="4202890" y="1547273"/>
              <a:ext cx="856188" cy="215444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ypoxic zone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DE8977C-80C8-15AF-B10F-C72097B11D5A}"/>
                </a:ext>
              </a:extLst>
            </p:cNvPr>
            <p:cNvSpPr txBox="1"/>
            <p:nvPr/>
          </p:nvSpPr>
          <p:spPr>
            <a:xfrm>
              <a:off x="3739658" y="1365179"/>
              <a:ext cx="660758" cy="461665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lacental 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villous 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ree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C2FA3C17-E4F3-D7C0-B1B8-7091FD5FDC9C}"/>
                </a:ext>
              </a:extLst>
            </p:cNvPr>
            <p:cNvSpPr txBox="1"/>
            <p:nvPr/>
          </p:nvSpPr>
          <p:spPr>
            <a:xfrm rot="19997556">
              <a:off x="4956983" y="1187553"/>
              <a:ext cx="98777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ailed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ransformation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f spiral arteries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9D852CC7-33B5-2332-3BFB-BBDFC926DBED}"/>
                </a:ext>
              </a:extLst>
            </p:cNvPr>
            <p:cNvCxnSpPr>
              <a:cxnSpLocks/>
              <a:stCxn id="53" idx="5"/>
            </p:cNvCxnSpPr>
            <p:nvPr/>
          </p:nvCxnSpPr>
          <p:spPr>
            <a:xfrm flipH="1" flipV="1">
              <a:off x="4697953" y="729914"/>
              <a:ext cx="632001" cy="969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832ED1BB-1FEF-F242-7AA6-F32A48EA20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66243" y="899387"/>
              <a:ext cx="315965" cy="454041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1D7F419E-824E-53A8-49C0-5BF40DC7CED6}"/>
                </a:ext>
              </a:extLst>
            </p:cNvPr>
            <p:cNvSpPr txBox="1"/>
            <p:nvPr/>
          </p:nvSpPr>
          <p:spPr>
            <a:xfrm rot="19959383">
              <a:off x="5654447" y="507586"/>
              <a:ext cx="6976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aternal</a:t>
              </a:r>
            </a:p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lood flow</a:t>
              </a:r>
            </a:p>
          </p:txBody>
        </p:sp>
        <p:sp>
          <p:nvSpPr>
            <p:cNvPr id="74" name="Freeform: Shape 73">
              <a:extLst>
                <a:ext uri="{FF2B5EF4-FFF2-40B4-BE49-F238E27FC236}">
                  <a16:creationId xmlns:a16="http://schemas.microsoft.com/office/drawing/2014/main" id="{09564E29-8EB3-4603-441A-5F7AF0C3172C}"/>
                </a:ext>
              </a:extLst>
            </p:cNvPr>
            <p:cNvSpPr/>
            <p:nvPr/>
          </p:nvSpPr>
          <p:spPr>
            <a:xfrm>
              <a:off x="4696950" y="745237"/>
              <a:ext cx="134161" cy="214514"/>
            </a:xfrm>
            <a:custGeom>
              <a:avLst/>
              <a:gdLst>
                <a:gd name="connsiteX0" fmla="*/ 119269 w 119269"/>
                <a:gd name="connsiteY0" fmla="*/ 122180 h 122180"/>
                <a:gd name="connsiteX1" fmla="*/ 20978 w 119269"/>
                <a:gd name="connsiteY1" fmla="*/ 68567 h 122180"/>
                <a:gd name="connsiteX2" fmla="*/ 3107 w 119269"/>
                <a:gd name="connsiteY2" fmla="*/ 6019 h 122180"/>
                <a:gd name="connsiteX3" fmla="*/ 128 w 119269"/>
                <a:gd name="connsiteY3" fmla="*/ 6019 h 122180"/>
                <a:gd name="connsiteX0" fmla="*/ 119269 w 119269"/>
                <a:gd name="connsiteY0" fmla="*/ 178772 h 178772"/>
                <a:gd name="connsiteX1" fmla="*/ 20978 w 119269"/>
                <a:gd name="connsiteY1" fmla="*/ 68567 h 178772"/>
                <a:gd name="connsiteX2" fmla="*/ 3107 w 119269"/>
                <a:gd name="connsiteY2" fmla="*/ 6019 h 178772"/>
                <a:gd name="connsiteX3" fmla="*/ 128 w 119269"/>
                <a:gd name="connsiteY3" fmla="*/ 6019 h 178772"/>
                <a:gd name="connsiteX0" fmla="*/ 134161 w 134161"/>
                <a:gd name="connsiteY0" fmla="*/ 214514 h 214514"/>
                <a:gd name="connsiteX1" fmla="*/ 20978 w 134161"/>
                <a:gd name="connsiteY1" fmla="*/ 68567 h 214514"/>
                <a:gd name="connsiteX2" fmla="*/ 3107 w 134161"/>
                <a:gd name="connsiteY2" fmla="*/ 6019 h 214514"/>
                <a:gd name="connsiteX3" fmla="*/ 128 w 134161"/>
                <a:gd name="connsiteY3" fmla="*/ 6019 h 21451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34161" h="214514">
                  <a:moveTo>
                    <a:pt x="134161" y="214514"/>
                  </a:moveTo>
                  <a:cubicBezTo>
                    <a:pt x="94695" y="197387"/>
                    <a:pt x="42820" y="103316"/>
                    <a:pt x="20978" y="68567"/>
                  </a:cubicBezTo>
                  <a:cubicBezTo>
                    <a:pt x="-864" y="33818"/>
                    <a:pt x="3107" y="6019"/>
                    <a:pt x="3107" y="6019"/>
                  </a:cubicBezTo>
                  <a:cubicBezTo>
                    <a:pt x="-368" y="-4406"/>
                    <a:pt x="-120" y="806"/>
                    <a:pt x="128" y="6019"/>
                  </a:cubicBezTo>
                </a:path>
              </a:pathLst>
            </a:custGeom>
            <a:noFill/>
            <a:ln w="6350">
              <a:tailEnd type="stealt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A0D98881-3B84-1A22-E6C4-344E5C8A4E3C}"/>
                </a:ext>
              </a:extLst>
            </p:cNvPr>
            <p:cNvSpPr txBox="1"/>
            <p:nvPr/>
          </p:nvSpPr>
          <p:spPr>
            <a:xfrm>
              <a:off x="4298460" y="1128631"/>
              <a:ext cx="3032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GB" sz="8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5B8DBBF7-A970-AC5C-05B7-F9851890EC28}"/>
                </a:ext>
              </a:extLst>
            </p:cNvPr>
            <p:cNvSpPr txBox="1"/>
            <p:nvPr/>
          </p:nvSpPr>
          <p:spPr>
            <a:xfrm rot="20061940">
              <a:off x="3716254" y="948510"/>
              <a:ext cx="856188" cy="215444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ypoxic zone</a:t>
              </a:r>
            </a:p>
          </p:txBody>
        </p:sp>
        <p:sp>
          <p:nvSpPr>
            <p:cNvPr id="77" name="Down Arrow 17">
              <a:extLst>
                <a:ext uri="{FF2B5EF4-FFF2-40B4-BE49-F238E27FC236}">
                  <a16:creationId xmlns:a16="http://schemas.microsoft.com/office/drawing/2014/main" id="{0D290AB4-A7F6-0229-B526-49986D8F02B3}"/>
                </a:ext>
              </a:extLst>
            </p:cNvPr>
            <p:cNvSpPr/>
            <p:nvPr/>
          </p:nvSpPr>
          <p:spPr>
            <a:xfrm rot="3824345">
              <a:off x="4706470" y="961060"/>
              <a:ext cx="178124" cy="249898"/>
            </a:xfrm>
            <a:prstGeom prst="downArrow">
              <a:avLst/>
            </a:prstGeom>
            <a:solidFill>
              <a:schemeClr val="tx1">
                <a:lumMod val="75000"/>
                <a:lumOff val="25000"/>
              </a:schemeClr>
            </a:solidFill>
            <a:ln w="0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26AD3E7D-749C-C1C5-47AD-C7ADBA67FF21}"/>
                </a:ext>
              </a:extLst>
            </p:cNvPr>
            <p:cNvSpPr txBox="1"/>
            <p:nvPr/>
          </p:nvSpPr>
          <p:spPr>
            <a:xfrm>
              <a:off x="4655243" y="769134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5AE7121-9A01-30D2-A68F-9B70110409E0}"/>
                </a:ext>
              </a:extLst>
            </p:cNvPr>
            <p:cNvSpPr txBox="1"/>
            <p:nvPr/>
          </p:nvSpPr>
          <p:spPr>
            <a:xfrm>
              <a:off x="4854503" y="1078114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  <p:sp>
          <p:nvSpPr>
            <p:cNvPr id="80" name="Freeform: Shape 79">
              <a:extLst>
                <a:ext uri="{FF2B5EF4-FFF2-40B4-BE49-F238E27FC236}">
                  <a16:creationId xmlns:a16="http://schemas.microsoft.com/office/drawing/2014/main" id="{0E13F28B-A327-A0B3-30BE-C628AB4F0739}"/>
                </a:ext>
              </a:extLst>
            </p:cNvPr>
            <p:cNvSpPr/>
            <p:nvPr/>
          </p:nvSpPr>
          <p:spPr>
            <a:xfrm rot="9876821">
              <a:off x="4956393" y="1117158"/>
              <a:ext cx="100283" cy="229408"/>
            </a:xfrm>
            <a:custGeom>
              <a:avLst/>
              <a:gdLst>
                <a:gd name="connsiteX0" fmla="*/ 119269 w 119269"/>
                <a:gd name="connsiteY0" fmla="*/ 122180 h 122180"/>
                <a:gd name="connsiteX1" fmla="*/ 20978 w 119269"/>
                <a:gd name="connsiteY1" fmla="*/ 68567 h 122180"/>
                <a:gd name="connsiteX2" fmla="*/ 3107 w 119269"/>
                <a:gd name="connsiteY2" fmla="*/ 6019 h 122180"/>
                <a:gd name="connsiteX3" fmla="*/ 128 w 119269"/>
                <a:gd name="connsiteY3" fmla="*/ 6019 h 122180"/>
                <a:gd name="connsiteX0" fmla="*/ 119269 w 119269"/>
                <a:gd name="connsiteY0" fmla="*/ 178772 h 178772"/>
                <a:gd name="connsiteX1" fmla="*/ 20978 w 119269"/>
                <a:gd name="connsiteY1" fmla="*/ 68567 h 178772"/>
                <a:gd name="connsiteX2" fmla="*/ 3107 w 119269"/>
                <a:gd name="connsiteY2" fmla="*/ 6019 h 178772"/>
                <a:gd name="connsiteX3" fmla="*/ 128 w 119269"/>
                <a:gd name="connsiteY3" fmla="*/ 6019 h 178772"/>
                <a:gd name="connsiteX0" fmla="*/ 134161 w 134161"/>
                <a:gd name="connsiteY0" fmla="*/ 214514 h 214514"/>
                <a:gd name="connsiteX1" fmla="*/ 20978 w 134161"/>
                <a:gd name="connsiteY1" fmla="*/ 68567 h 214514"/>
                <a:gd name="connsiteX2" fmla="*/ 3107 w 134161"/>
                <a:gd name="connsiteY2" fmla="*/ 6019 h 214514"/>
                <a:gd name="connsiteX3" fmla="*/ 128 w 134161"/>
                <a:gd name="connsiteY3" fmla="*/ 6019 h 214514"/>
                <a:gd name="connsiteX0" fmla="*/ 134161 w 134161"/>
                <a:gd name="connsiteY0" fmla="*/ 214514 h 214514"/>
                <a:gd name="connsiteX1" fmla="*/ 71167 w 134161"/>
                <a:gd name="connsiteY1" fmla="*/ 54576 h 214514"/>
                <a:gd name="connsiteX2" fmla="*/ 3107 w 134161"/>
                <a:gd name="connsiteY2" fmla="*/ 6019 h 214514"/>
                <a:gd name="connsiteX3" fmla="*/ 128 w 134161"/>
                <a:gd name="connsiteY3" fmla="*/ 6019 h 214514"/>
                <a:gd name="connsiteX0" fmla="*/ 130499 w 130499"/>
                <a:gd name="connsiteY0" fmla="*/ 216594 h 216594"/>
                <a:gd name="connsiteX1" fmla="*/ 71167 w 130499"/>
                <a:gd name="connsiteY1" fmla="*/ 54576 h 216594"/>
                <a:gd name="connsiteX2" fmla="*/ 3107 w 130499"/>
                <a:gd name="connsiteY2" fmla="*/ 6019 h 216594"/>
                <a:gd name="connsiteX3" fmla="*/ 128 w 130499"/>
                <a:gd name="connsiteY3" fmla="*/ 6019 h 216594"/>
                <a:gd name="connsiteX0" fmla="*/ 130499 w 130499"/>
                <a:gd name="connsiteY0" fmla="*/ 216594 h 216594"/>
                <a:gd name="connsiteX1" fmla="*/ 85736 w 130499"/>
                <a:gd name="connsiteY1" fmla="*/ 80210 h 216594"/>
                <a:gd name="connsiteX2" fmla="*/ 3107 w 130499"/>
                <a:gd name="connsiteY2" fmla="*/ 6019 h 216594"/>
                <a:gd name="connsiteX3" fmla="*/ 128 w 130499"/>
                <a:gd name="connsiteY3" fmla="*/ 6019 h 216594"/>
                <a:gd name="connsiteX0" fmla="*/ 130499 w 130499"/>
                <a:gd name="connsiteY0" fmla="*/ 216594 h 216594"/>
                <a:gd name="connsiteX1" fmla="*/ 116167 w 130499"/>
                <a:gd name="connsiteY1" fmla="*/ 138012 h 216594"/>
                <a:gd name="connsiteX2" fmla="*/ 3107 w 130499"/>
                <a:gd name="connsiteY2" fmla="*/ 6019 h 216594"/>
                <a:gd name="connsiteX3" fmla="*/ 128 w 130499"/>
                <a:gd name="connsiteY3" fmla="*/ 6019 h 216594"/>
                <a:gd name="connsiteX0" fmla="*/ 116167 w 116167"/>
                <a:gd name="connsiteY0" fmla="*/ 138012 h 138012"/>
                <a:gd name="connsiteX1" fmla="*/ 3107 w 116167"/>
                <a:gd name="connsiteY1" fmla="*/ 6019 h 138012"/>
                <a:gd name="connsiteX2" fmla="*/ 128 w 116167"/>
                <a:gd name="connsiteY2" fmla="*/ 6019 h 138012"/>
                <a:gd name="connsiteX0" fmla="*/ 160456 w 160456"/>
                <a:gd name="connsiteY0" fmla="*/ 190360 h 190360"/>
                <a:gd name="connsiteX1" fmla="*/ 3107 w 160456"/>
                <a:gd name="connsiteY1" fmla="*/ 6019 h 190360"/>
                <a:gd name="connsiteX2" fmla="*/ 128 w 160456"/>
                <a:gd name="connsiteY2" fmla="*/ 6019 h 190360"/>
                <a:gd name="connsiteX0" fmla="*/ 100283 w 100283"/>
                <a:gd name="connsiteY0" fmla="*/ 229408 h 229408"/>
                <a:gd name="connsiteX1" fmla="*/ 3107 w 100283"/>
                <a:gd name="connsiteY1" fmla="*/ 6019 h 229408"/>
                <a:gd name="connsiteX2" fmla="*/ 128 w 100283"/>
                <a:gd name="connsiteY2" fmla="*/ 6019 h 229408"/>
                <a:gd name="connsiteX0" fmla="*/ 100283 w 100283"/>
                <a:gd name="connsiteY0" fmla="*/ 229408 h 229408"/>
                <a:gd name="connsiteX1" fmla="*/ 54979 w 100283"/>
                <a:gd name="connsiteY1" fmla="*/ 141835 h 229408"/>
                <a:gd name="connsiteX2" fmla="*/ 3107 w 100283"/>
                <a:gd name="connsiteY2" fmla="*/ 6019 h 229408"/>
                <a:gd name="connsiteX3" fmla="*/ 128 w 100283"/>
                <a:gd name="connsiteY3" fmla="*/ 6019 h 229408"/>
                <a:gd name="connsiteX0" fmla="*/ 100283 w 100283"/>
                <a:gd name="connsiteY0" fmla="*/ 229408 h 229408"/>
                <a:gd name="connsiteX1" fmla="*/ 68336 w 100283"/>
                <a:gd name="connsiteY1" fmla="*/ 126976 h 229408"/>
                <a:gd name="connsiteX2" fmla="*/ 3107 w 100283"/>
                <a:gd name="connsiteY2" fmla="*/ 6019 h 229408"/>
                <a:gd name="connsiteX3" fmla="*/ 128 w 100283"/>
                <a:gd name="connsiteY3" fmla="*/ 6019 h 22940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0283" h="229408">
                  <a:moveTo>
                    <a:pt x="100283" y="229408"/>
                  </a:moveTo>
                  <a:cubicBezTo>
                    <a:pt x="92732" y="214813"/>
                    <a:pt x="84532" y="164207"/>
                    <a:pt x="68336" y="126976"/>
                  </a:cubicBezTo>
                  <a:cubicBezTo>
                    <a:pt x="52140" y="89745"/>
                    <a:pt x="12249" y="28655"/>
                    <a:pt x="3107" y="6019"/>
                  </a:cubicBezTo>
                  <a:cubicBezTo>
                    <a:pt x="-368" y="-4406"/>
                    <a:pt x="-120" y="806"/>
                    <a:pt x="128" y="6019"/>
                  </a:cubicBezTo>
                </a:path>
              </a:pathLst>
            </a:custGeom>
            <a:noFill/>
            <a:ln w="6350">
              <a:tailEnd type="stealt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C6257D9D-9BA9-280A-D00E-21DAC8E1ACA9}"/>
              </a:ext>
            </a:extLst>
          </p:cNvPr>
          <p:cNvGrpSpPr/>
          <p:nvPr/>
        </p:nvGrpSpPr>
        <p:grpSpPr>
          <a:xfrm>
            <a:off x="3304026" y="3352284"/>
            <a:ext cx="1191446" cy="1759668"/>
            <a:chOff x="6113960" y="4040012"/>
            <a:chExt cx="1668273" cy="2117064"/>
          </a:xfrm>
        </p:grpSpPr>
        <p:pic>
          <p:nvPicPr>
            <p:cNvPr id="115" name="Picture 114">
              <a:extLst>
                <a:ext uri="{FF2B5EF4-FFF2-40B4-BE49-F238E27FC236}">
                  <a16:creationId xmlns:a16="http://schemas.microsoft.com/office/drawing/2014/main" id="{DA4FAD17-D311-F55A-CF8C-6648BAD60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638718" y="4916943"/>
              <a:ext cx="1123871" cy="1240133"/>
            </a:xfrm>
            <a:prstGeom prst="rect">
              <a:avLst/>
            </a:prstGeom>
          </p:spPr>
        </p:pic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012FC340-DEDA-6464-5B7B-D4ADF63084E4}"/>
                </a:ext>
              </a:extLst>
            </p:cNvPr>
            <p:cNvSpPr txBox="1"/>
            <p:nvPr/>
          </p:nvSpPr>
          <p:spPr>
            <a:xfrm>
              <a:off x="6359306" y="4040012"/>
              <a:ext cx="94448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eme</a:t>
              </a:r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handling 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fence </a:t>
              </a:r>
            </a:p>
            <a:p>
              <a:pPr algn="ctr"/>
              <a:r>
                <a:rPr lang="en-GB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pletion</a:t>
              </a:r>
            </a:p>
          </p:txBody>
        </p:sp>
        <p:sp>
          <p:nvSpPr>
            <p:cNvPr id="117" name="Curved Right Arrow 80">
              <a:extLst>
                <a:ext uri="{FF2B5EF4-FFF2-40B4-BE49-F238E27FC236}">
                  <a16:creationId xmlns:a16="http://schemas.microsoft.com/office/drawing/2014/main" id="{BD6BB630-56C1-F7CA-518B-1E1B32046630}"/>
                </a:ext>
              </a:extLst>
            </p:cNvPr>
            <p:cNvSpPr/>
            <p:nvPr/>
          </p:nvSpPr>
          <p:spPr>
            <a:xfrm rot="20218996">
              <a:off x="6113960" y="4427427"/>
              <a:ext cx="439240" cy="1066499"/>
            </a:xfrm>
            <a:prstGeom prst="curved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  <p:sp>
          <p:nvSpPr>
            <p:cNvPr id="118" name="Curved Right Arrow 85">
              <a:extLst>
                <a:ext uri="{FF2B5EF4-FFF2-40B4-BE49-F238E27FC236}">
                  <a16:creationId xmlns:a16="http://schemas.microsoft.com/office/drawing/2014/main" id="{0A3F39CD-41CD-8122-FD2D-C4E30677334B}"/>
                </a:ext>
              </a:extLst>
            </p:cNvPr>
            <p:cNvSpPr/>
            <p:nvPr/>
          </p:nvSpPr>
          <p:spPr>
            <a:xfrm rot="10380700">
              <a:off x="7330503" y="4239357"/>
              <a:ext cx="451730" cy="923244"/>
            </a:xfrm>
            <a:prstGeom prst="curvedRight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tx1"/>
                </a:solidFill>
              </a:endParaRPr>
            </a:p>
          </p:txBody>
        </p: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25DF531B-5A7E-EE83-2383-284A307807E9}"/>
              </a:ext>
            </a:extLst>
          </p:cNvPr>
          <p:cNvSpPr txBox="1"/>
          <p:nvPr/>
        </p:nvSpPr>
        <p:spPr>
          <a:xfrm>
            <a:off x="2726062" y="4604895"/>
            <a:ext cx="4154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>
                <a:latin typeface="Arial" panose="020B0604020202020204" pitchFamily="34" charset="0"/>
                <a:cs typeface="Arial" panose="020B0604020202020204" pitchFamily="34" charset="0"/>
              </a:rPr>
              <a:t>lysis</a:t>
            </a:r>
          </a:p>
        </p:txBody>
      </p:sp>
    </p:spTree>
    <p:extLst>
      <p:ext uri="{BB962C8B-B14F-4D97-AF65-F5344CB8AC3E}">
        <p14:creationId xmlns:p14="http://schemas.microsoft.com/office/powerpoint/2010/main" val="1149164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80</TotalTime>
  <Words>147</Words>
  <Application>Microsoft Office PowerPoint</Application>
  <PresentationFormat>Custom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ownbill</dc:creator>
  <cp:lastModifiedBy>Paul Brownbill</cp:lastModifiedBy>
  <cp:revision>6</cp:revision>
  <dcterms:created xsi:type="dcterms:W3CDTF">2024-03-18T08:26:42Z</dcterms:created>
  <dcterms:modified xsi:type="dcterms:W3CDTF">2024-11-29T14:56:38Z</dcterms:modified>
</cp:coreProperties>
</file>